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5"/>
  </p:notesMasterIdLst>
  <p:sldIdLst>
    <p:sldId id="382" r:id="rId2"/>
    <p:sldId id="412" r:id="rId3"/>
    <p:sldId id="383" r:id="rId4"/>
    <p:sldId id="424" r:id="rId5"/>
    <p:sldId id="408" r:id="rId6"/>
    <p:sldId id="423" r:id="rId7"/>
    <p:sldId id="403" r:id="rId8"/>
    <p:sldId id="426" r:id="rId9"/>
    <p:sldId id="404" r:id="rId10"/>
    <p:sldId id="389" r:id="rId11"/>
    <p:sldId id="422" r:id="rId12"/>
    <p:sldId id="418" r:id="rId13"/>
    <p:sldId id="429" r:id="rId14"/>
  </p:sldIdLst>
  <p:sldSz cx="6858000" cy="9906000" type="A4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wadiae, Faith" initials="UF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BE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04" autoAdjust="0"/>
    <p:restoredTop sz="87618" autoAdjust="0"/>
  </p:normalViewPr>
  <p:slideViewPr>
    <p:cSldViewPr snapToGrid="0">
      <p:cViewPr>
        <p:scale>
          <a:sx n="150" d="100"/>
          <a:sy n="150" d="100"/>
        </p:scale>
        <p:origin x="426" y="-269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80" d="100"/>
        <a:sy n="8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image" Target="../media/image11.wmf"/><Relationship Id="rId1" Type="http://schemas.openxmlformats.org/officeDocument/2006/relationships/image" Target="../media/image10.wmf"/><Relationship Id="rId4" Type="http://schemas.openxmlformats.org/officeDocument/2006/relationships/image" Target="../media/image13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3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66.wmf"/><Relationship Id="rId2" Type="http://schemas.openxmlformats.org/officeDocument/2006/relationships/image" Target="../media/image65.wmf"/><Relationship Id="rId1" Type="http://schemas.openxmlformats.org/officeDocument/2006/relationships/image" Target="../media/image64.wmf"/><Relationship Id="rId6" Type="http://schemas.openxmlformats.org/officeDocument/2006/relationships/image" Target="../media/image69.wmf"/><Relationship Id="rId5" Type="http://schemas.openxmlformats.org/officeDocument/2006/relationships/image" Target="../media/image68.wmf"/><Relationship Id="rId4" Type="http://schemas.openxmlformats.org/officeDocument/2006/relationships/image" Target="../media/image67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85.wmf"/><Relationship Id="rId2" Type="http://schemas.openxmlformats.org/officeDocument/2006/relationships/image" Target="../media/image84.wmf"/><Relationship Id="rId1" Type="http://schemas.openxmlformats.org/officeDocument/2006/relationships/image" Target="../media/image83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88.wmf"/><Relationship Id="rId2" Type="http://schemas.openxmlformats.org/officeDocument/2006/relationships/image" Target="../media/image87.wmf"/><Relationship Id="rId1" Type="http://schemas.openxmlformats.org/officeDocument/2006/relationships/image" Target="../media/image86.wmf"/><Relationship Id="rId6" Type="http://schemas.openxmlformats.org/officeDocument/2006/relationships/image" Target="../media/image91.wmf"/><Relationship Id="rId5" Type="http://schemas.openxmlformats.org/officeDocument/2006/relationships/image" Target="../media/image90.wmf"/><Relationship Id="rId4" Type="http://schemas.openxmlformats.org/officeDocument/2006/relationships/image" Target="../media/image89.w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94.wmf"/><Relationship Id="rId2" Type="http://schemas.openxmlformats.org/officeDocument/2006/relationships/image" Target="../media/image93.wmf"/><Relationship Id="rId1" Type="http://schemas.openxmlformats.org/officeDocument/2006/relationships/image" Target="../media/image92.wmf"/></Relationships>
</file>

<file path=ppt/drawings/_rels/vmlDrawing7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8.wmf"/><Relationship Id="rId3" Type="http://schemas.openxmlformats.org/officeDocument/2006/relationships/image" Target="../media/image103.wmf"/><Relationship Id="rId7" Type="http://schemas.openxmlformats.org/officeDocument/2006/relationships/image" Target="../media/image107.wmf"/><Relationship Id="rId2" Type="http://schemas.openxmlformats.org/officeDocument/2006/relationships/image" Target="../media/image102.wmf"/><Relationship Id="rId1" Type="http://schemas.openxmlformats.org/officeDocument/2006/relationships/image" Target="../media/image101.wmf"/><Relationship Id="rId6" Type="http://schemas.openxmlformats.org/officeDocument/2006/relationships/image" Target="../media/image106.wmf"/><Relationship Id="rId5" Type="http://schemas.openxmlformats.org/officeDocument/2006/relationships/image" Target="../media/image105.wmf"/><Relationship Id="rId4" Type="http://schemas.openxmlformats.org/officeDocument/2006/relationships/image" Target="../media/image104.wmf"/></Relationships>
</file>

<file path=ppt/drawings/_rels/vmlDrawing8.v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wmf"/><Relationship Id="rId3" Type="http://schemas.openxmlformats.org/officeDocument/2006/relationships/image" Target="../media/image115.wmf"/><Relationship Id="rId7" Type="http://schemas.openxmlformats.org/officeDocument/2006/relationships/image" Target="../media/image119.wmf"/><Relationship Id="rId2" Type="http://schemas.openxmlformats.org/officeDocument/2006/relationships/image" Target="../media/image114.wmf"/><Relationship Id="rId1" Type="http://schemas.openxmlformats.org/officeDocument/2006/relationships/image" Target="../media/image113.wmf"/><Relationship Id="rId6" Type="http://schemas.openxmlformats.org/officeDocument/2006/relationships/image" Target="../media/image118.wmf"/><Relationship Id="rId5" Type="http://schemas.openxmlformats.org/officeDocument/2006/relationships/image" Target="../media/image117.wmf"/><Relationship Id="rId4" Type="http://schemas.openxmlformats.org/officeDocument/2006/relationships/image" Target="../media/image116.w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0.wmf"/><Relationship Id="rId1" Type="http://schemas.openxmlformats.org/officeDocument/2006/relationships/image" Target="../media/image12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AAB258-F038-44F2-87E4-681094D50B4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41425"/>
            <a:ext cx="23161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77958"/>
            <a:ext cx="533527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889938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30091"/>
            <a:ext cx="2889938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B530EF-F54B-44B5-81E2-569249889B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36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8575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7779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GB" sz="12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B9D73A-4EEE-4F95-8EF6-9F92D707D562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9612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1643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20124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09415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604874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530EF-F54B-44B5-81E2-569249889BBD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263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9725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680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685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55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1552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965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2411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1890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485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759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79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017CB-3FD1-4306-863F-497A56472DC1}" type="datetimeFigureOut">
              <a:rPr lang="en-GB" smtClean="0"/>
              <a:t>26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BC640-AE05-4D6E-A3F0-05CD458AAB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947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1.bin"/><Relationship Id="rId13" Type="http://schemas.openxmlformats.org/officeDocument/2006/relationships/image" Target="../media/image100.tiff"/><Relationship Id="rId3" Type="http://schemas.openxmlformats.org/officeDocument/2006/relationships/notesSlide" Target="../notesSlides/notesSlide7.xml"/><Relationship Id="rId7" Type="http://schemas.openxmlformats.org/officeDocument/2006/relationships/image" Target="../media/image98.tiff"/><Relationship Id="rId12" Type="http://schemas.openxmlformats.org/officeDocument/2006/relationships/image" Target="../media/image99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97.tiff"/><Relationship Id="rId11" Type="http://schemas.openxmlformats.org/officeDocument/2006/relationships/image" Target="../media/image93.wmf"/><Relationship Id="rId5" Type="http://schemas.openxmlformats.org/officeDocument/2006/relationships/image" Target="../media/image96.tiff"/><Relationship Id="rId15" Type="http://schemas.openxmlformats.org/officeDocument/2006/relationships/image" Target="../media/image94.wmf"/><Relationship Id="rId10" Type="http://schemas.openxmlformats.org/officeDocument/2006/relationships/oleObject" Target="../embeddings/oleObject22.bin"/><Relationship Id="rId4" Type="http://schemas.openxmlformats.org/officeDocument/2006/relationships/image" Target="../media/image95.tiff"/><Relationship Id="rId9" Type="http://schemas.openxmlformats.org/officeDocument/2006/relationships/image" Target="../media/image92.wmf"/><Relationship Id="rId14" Type="http://schemas.openxmlformats.org/officeDocument/2006/relationships/oleObject" Target="../embeddings/oleObject23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wmf"/><Relationship Id="rId13" Type="http://schemas.openxmlformats.org/officeDocument/2006/relationships/oleObject" Target="../embeddings/oleObject27.bin"/><Relationship Id="rId18" Type="http://schemas.openxmlformats.org/officeDocument/2006/relationships/image" Target="../media/image106.wmf"/><Relationship Id="rId3" Type="http://schemas.openxmlformats.org/officeDocument/2006/relationships/image" Target="../media/image109.png"/><Relationship Id="rId21" Type="http://schemas.openxmlformats.org/officeDocument/2006/relationships/oleObject" Target="../embeddings/oleObject31.bin"/><Relationship Id="rId7" Type="http://schemas.openxmlformats.org/officeDocument/2006/relationships/oleObject" Target="../embeddings/oleObject24.bin"/><Relationship Id="rId12" Type="http://schemas.openxmlformats.org/officeDocument/2006/relationships/image" Target="../media/image103.wmf"/><Relationship Id="rId17" Type="http://schemas.openxmlformats.org/officeDocument/2006/relationships/oleObject" Target="../embeddings/oleObject2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5.wmf"/><Relationship Id="rId20" Type="http://schemas.openxmlformats.org/officeDocument/2006/relationships/image" Target="../media/image107.wmf"/><Relationship Id="rId1" Type="http://schemas.openxmlformats.org/officeDocument/2006/relationships/vmlDrawing" Target="../drawings/vmlDrawing7.vml"/><Relationship Id="rId6" Type="http://schemas.openxmlformats.org/officeDocument/2006/relationships/image" Target="../media/image112.png"/><Relationship Id="rId11" Type="http://schemas.openxmlformats.org/officeDocument/2006/relationships/oleObject" Target="../embeddings/oleObject26.bin"/><Relationship Id="rId5" Type="http://schemas.openxmlformats.org/officeDocument/2006/relationships/image" Target="../media/image111.png"/><Relationship Id="rId15" Type="http://schemas.openxmlformats.org/officeDocument/2006/relationships/oleObject" Target="../embeddings/oleObject28.bin"/><Relationship Id="rId10" Type="http://schemas.openxmlformats.org/officeDocument/2006/relationships/image" Target="../media/image102.wmf"/><Relationship Id="rId19" Type="http://schemas.openxmlformats.org/officeDocument/2006/relationships/oleObject" Target="../embeddings/oleObject30.bin"/><Relationship Id="rId4" Type="http://schemas.openxmlformats.org/officeDocument/2006/relationships/image" Target="../media/image110.png"/><Relationship Id="rId9" Type="http://schemas.openxmlformats.org/officeDocument/2006/relationships/oleObject" Target="../embeddings/oleObject25.bin"/><Relationship Id="rId14" Type="http://schemas.openxmlformats.org/officeDocument/2006/relationships/image" Target="../media/image104.wmf"/><Relationship Id="rId22" Type="http://schemas.openxmlformats.org/officeDocument/2006/relationships/image" Target="../media/image108.w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4.bin"/><Relationship Id="rId13" Type="http://schemas.openxmlformats.org/officeDocument/2006/relationships/image" Target="../media/image122.png"/><Relationship Id="rId18" Type="http://schemas.openxmlformats.org/officeDocument/2006/relationships/image" Target="../media/image127.png"/><Relationship Id="rId26" Type="http://schemas.openxmlformats.org/officeDocument/2006/relationships/oleObject" Target="../embeddings/oleObject39.bin"/><Relationship Id="rId3" Type="http://schemas.openxmlformats.org/officeDocument/2006/relationships/notesSlide" Target="../notesSlides/notesSlide8.xml"/><Relationship Id="rId21" Type="http://schemas.openxmlformats.org/officeDocument/2006/relationships/image" Target="../media/image117.wmf"/><Relationship Id="rId7" Type="http://schemas.openxmlformats.org/officeDocument/2006/relationships/image" Target="../media/image114.wmf"/><Relationship Id="rId12" Type="http://schemas.openxmlformats.org/officeDocument/2006/relationships/image" Target="../media/image121.png"/><Relationship Id="rId17" Type="http://schemas.openxmlformats.org/officeDocument/2006/relationships/image" Target="../media/image126.png"/><Relationship Id="rId25" Type="http://schemas.openxmlformats.org/officeDocument/2006/relationships/image" Target="../media/image119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5.png"/><Relationship Id="rId20" Type="http://schemas.openxmlformats.org/officeDocument/2006/relationships/oleObject" Target="../embeddings/oleObject36.bin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33.bin"/><Relationship Id="rId11" Type="http://schemas.openxmlformats.org/officeDocument/2006/relationships/image" Target="../media/image116.wmf"/><Relationship Id="rId24" Type="http://schemas.openxmlformats.org/officeDocument/2006/relationships/oleObject" Target="../embeddings/oleObject38.bin"/><Relationship Id="rId5" Type="http://schemas.openxmlformats.org/officeDocument/2006/relationships/image" Target="../media/image113.wmf"/><Relationship Id="rId15" Type="http://schemas.openxmlformats.org/officeDocument/2006/relationships/image" Target="../media/image124.png"/><Relationship Id="rId23" Type="http://schemas.openxmlformats.org/officeDocument/2006/relationships/image" Target="../media/image118.wmf"/><Relationship Id="rId10" Type="http://schemas.openxmlformats.org/officeDocument/2006/relationships/oleObject" Target="../embeddings/oleObject35.bin"/><Relationship Id="rId19" Type="http://schemas.openxmlformats.org/officeDocument/2006/relationships/image" Target="../media/image128.png"/><Relationship Id="rId4" Type="http://schemas.openxmlformats.org/officeDocument/2006/relationships/oleObject" Target="../embeddings/oleObject32.bin"/><Relationship Id="rId9" Type="http://schemas.openxmlformats.org/officeDocument/2006/relationships/image" Target="../media/image115.wmf"/><Relationship Id="rId14" Type="http://schemas.openxmlformats.org/officeDocument/2006/relationships/image" Target="../media/image123.png"/><Relationship Id="rId22" Type="http://schemas.openxmlformats.org/officeDocument/2006/relationships/oleObject" Target="../embeddings/oleObject37.bin"/><Relationship Id="rId27" Type="http://schemas.openxmlformats.org/officeDocument/2006/relationships/image" Target="../media/image120.w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9.wmf"/><Relationship Id="rId3" Type="http://schemas.openxmlformats.org/officeDocument/2006/relationships/image" Target="../media/image131.tiff"/><Relationship Id="rId7" Type="http://schemas.openxmlformats.org/officeDocument/2006/relationships/oleObject" Target="../embeddings/oleObject4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34.tiff"/><Relationship Id="rId5" Type="http://schemas.openxmlformats.org/officeDocument/2006/relationships/image" Target="../media/image133.tiff"/><Relationship Id="rId10" Type="http://schemas.openxmlformats.org/officeDocument/2006/relationships/image" Target="../media/image130.wmf"/><Relationship Id="rId4" Type="http://schemas.openxmlformats.org/officeDocument/2006/relationships/image" Target="../media/image132.tiff"/><Relationship Id="rId9" Type="http://schemas.openxmlformats.org/officeDocument/2006/relationships/oleObject" Target="../embeddings/oleObject4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18" Type="http://schemas.openxmlformats.org/officeDocument/2006/relationships/oleObject" Target="../embeddings/oleObject4.bin"/><Relationship Id="rId26" Type="http://schemas.openxmlformats.org/officeDocument/2006/relationships/image" Target="../media/image28.png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23.png"/><Relationship Id="rId7" Type="http://schemas.openxmlformats.org/officeDocument/2006/relationships/image" Target="../media/image11.wmf"/><Relationship Id="rId12" Type="http://schemas.openxmlformats.org/officeDocument/2006/relationships/image" Target="../media/image18.png"/><Relationship Id="rId17" Type="http://schemas.openxmlformats.org/officeDocument/2006/relationships/image" Target="../media/image12.wmf"/><Relationship Id="rId25" Type="http://schemas.openxmlformats.org/officeDocument/2006/relationships/image" Target="../media/image27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.bin"/><Relationship Id="rId20" Type="http://schemas.openxmlformats.org/officeDocument/2006/relationships/image" Target="../media/image22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7.png"/><Relationship Id="rId24" Type="http://schemas.openxmlformats.org/officeDocument/2006/relationships/image" Target="../media/image26.png"/><Relationship Id="rId5" Type="http://schemas.openxmlformats.org/officeDocument/2006/relationships/image" Target="../media/image10.wmf"/><Relationship Id="rId15" Type="http://schemas.openxmlformats.org/officeDocument/2006/relationships/image" Target="../media/image21.png"/><Relationship Id="rId23" Type="http://schemas.openxmlformats.org/officeDocument/2006/relationships/image" Target="../media/image25.png"/><Relationship Id="rId10" Type="http://schemas.openxmlformats.org/officeDocument/2006/relationships/image" Target="../media/image16.png"/><Relationship Id="rId19" Type="http://schemas.openxmlformats.org/officeDocument/2006/relationships/image" Target="../media/image13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15.png"/><Relationship Id="rId14" Type="http://schemas.openxmlformats.org/officeDocument/2006/relationships/image" Target="../media/image20.png"/><Relationship Id="rId22" Type="http://schemas.openxmlformats.org/officeDocument/2006/relationships/image" Target="../media/image24.png"/><Relationship Id="rId27" Type="http://schemas.openxmlformats.org/officeDocument/2006/relationships/image" Target="../media/image2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openxmlformats.org/officeDocument/2006/relationships/image" Target="../media/image49.png"/><Relationship Id="rId18" Type="http://schemas.openxmlformats.org/officeDocument/2006/relationships/image" Target="../media/image54.png"/><Relationship Id="rId26" Type="http://schemas.openxmlformats.org/officeDocument/2006/relationships/image" Target="../media/image62.png"/><Relationship Id="rId3" Type="http://schemas.openxmlformats.org/officeDocument/2006/relationships/image" Target="../media/image39.png"/><Relationship Id="rId21" Type="http://schemas.openxmlformats.org/officeDocument/2006/relationships/image" Target="../media/image57.png"/><Relationship Id="rId7" Type="http://schemas.openxmlformats.org/officeDocument/2006/relationships/image" Target="../media/image43.png"/><Relationship Id="rId12" Type="http://schemas.openxmlformats.org/officeDocument/2006/relationships/image" Target="../media/image48.png"/><Relationship Id="rId17" Type="http://schemas.openxmlformats.org/officeDocument/2006/relationships/image" Target="../media/image53.png"/><Relationship Id="rId25" Type="http://schemas.openxmlformats.org/officeDocument/2006/relationships/image" Target="../media/image61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2.png"/><Relationship Id="rId20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png"/><Relationship Id="rId11" Type="http://schemas.openxmlformats.org/officeDocument/2006/relationships/image" Target="../media/image47.png"/><Relationship Id="rId24" Type="http://schemas.openxmlformats.org/officeDocument/2006/relationships/image" Target="../media/image60.png"/><Relationship Id="rId5" Type="http://schemas.openxmlformats.org/officeDocument/2006/relationships/image" Target="../media/image41.png"/><Relationship Id="rId15" Type="http://schemas.openxmlformats.org/officeDocument/2006/relationships/image" Target="../media/image51.png"/><Relationship Id="rId23" Type="http://schemas.openxmlformats.org/officeDocument/2006/relationships/image" Target="../media/image59.png"/><Relationship Id="rId10" Type="http://schemas.openxmlformats.org/officeDocument/2006/relationships/image" Target="../media/image46.png"/><Relationship Id="rId19" Type="http://schemas.openxmlformats.org/officeDocument/2006/relationships/image" Target="../media/image55.png"/><Relationship Id="rId4" Type="http://schemas.openxmlformats.org/officeDocument/2006/relationships/image" Target="../media/image40.png"/><Relationship Id="rId9" Type="http://schemas.openxmlformats.org/officeDocument/2006/relationships/image" Target="../media/image45.png"/><Relationship Id="rId14" Type="http://schemas.openxmlformats.org/officeDocument/2006/relationships/image" Target="../media/image50.png"/><Relationship Id="rId22" Type="http://schemas.openxmlformats.org/officeDocument/2006/relationships/image" Target="../media/image5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3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71.png"/><Relationship Id="rId18" Type="http://schemas.openxmlformats.org/officeDocument/2006/relationships/image" Target="../media/image76.png"/><Relationship Id="rId26" Type="http://schemas.openxmlformats.org/officeDocument/2006/relationships/image" Target="../media/image68.wmf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79.tiff"/><Relationship Id="rId7" Type="http://schemas.openxmlformats.org/officeDocument/2006/relationships/image" Target="../media/image65.wmf"/><Relationship Id="rId12" Type="http://schemas.openxmlformats.org/officeDocument/2006/relationships/image" Target="../media/image70.png"/><Relationship Id="rId17" Type="http://schemas.openxmlformats.org/officeDocument/2006/relationships/image" Target="../media/image75.png"/><Relationship Id="rId25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4.png"/><Relationship Id="rId20" Type="http://schemas.openxmlformats.org/officeDocument/2006/relationships/image" Target="../media/image78.png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67.wmf"/><Relationship Id="rId24" Type="http://schemas.openxmlformats.org/officeDocument/2006/relationships/image" Target="../media/image82.tiff"/><Relationship Id="rId5" Type="http://schemas.openxmlformats.org/officeDocument/2006/relationships/image" Target="../media/image64.wmf"/><Relationship Id="rId15" Type="http://schemas.openxmlformats.org/officeDocument/2006/relationships/image" Target="../media/image73.png"/><Relationship Id="rId23" Type="http://schemas.openxmlformats.org/officeDocument/2006/relationships/image" Target="../media/image81.tiff"/><Relationship Id="rId28" Type="http://schemas.openxmlformats.org/officeDocument/2006/relationships/image" Target="../media/image69.wmf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77.png"/><Relationship Id="rId4" Type="http://schemas.openxmlformats.org/officeDocument/2006/relationships/oleObject" Target="../embeddings/oleObject6.bin"/><Relationship Id="rId9" Type="http://schemas.openxmlformats.org/officeDocument/2006/relationships/image" Target="../media/image66.wmf"/><Relationship Id="rId14" Type="http://schemas.openxmlformats.org/officeDocument/2006/relationships/image" Target="../media/image72.png"/><Relationship Id="rId22" Type="http://schemas.openxmlformats.org/officeDocument/2006/relationships/image" Target="../media/image80.tiff"/><Relationship Id="rId27" Type="http://schemas.openxmlformats.org/officeDocument/2006/relationships/oleObject" Target="../embeddings/oleObject11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w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4.w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83.w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13" Type="http://schemas.openxmlformats.org/officeDocument/2006/relationships/image" Target="../media/image90.wmf"/><Relationship Id="rId3" Type="http://schemas.openxmlformats.org/officeDocument/2006/relationships/notesSlide" Target="../notesSlides/notesSlide6.xml"/><Relationship Id="rId7" Type="http://schemas.openxmlformats.org/officeDocument/2006/relationships/image" Target="../media/image87.wmf"/><Relationship Id="rId12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89.wmf"/><Relationship Id="rId5" Type="http://schemas.openxmlformats.org/officeDocument/2006/relationships/image" Target="../media/image86.wmf"/><Relationship Id="rId15" Type="http://schemas.openxmlformats.org/officeDocument/2006/relationships/image" Target="../media/image91.w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88.wmf"/><Relationship Id="rId14" Type="http://schemas.openxmlformats.org/officeDocument/2006/relationships/oleObject" Target="../embeddings/oleObject2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56352" y="6300636"/>
            <a:ext cx="63016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Table S1: Flow cytometry antibodies used in the study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Lineage negative (Lin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cells were defined as: CD11b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CR-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β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ER119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GR1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endParaRPr lang="en-GB" sz="10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695897" y="656170"/>
          <a:ext cx="5575935" cy="5381640"/>
        </p:xfrm>
        <a:graphic>
          <a:graphicData uri="http://schemas.openxmlformats.org/drawingml/2006/table">
            <a:tbl>
              <a:tblPr firstRow="1" firstCol="1" bandRow="1"/>
              <a:tblGrid>
                <a:gridCol w="807085"/>
                <a:gridCol w="1170305"/>
                <a:gridCol w="1170305"/>
                <a:gridCol w="989965"/>
                <a:gridCol w="1438275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pli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orochrome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22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3-6B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5-2C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-CF59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M4-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/CY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8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3-6.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1b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1/7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1b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1/7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D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D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8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exa7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	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-F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62L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L-1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933450" algn="l"/>
                        </a:tabLs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90-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-H1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exa7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XCR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138D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2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S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A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5773-8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6-8C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a/I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5/114.15.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3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2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-γ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XMG1.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51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-26c.2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cific Blu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M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MM-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/CY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13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17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11-18H10.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kp4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A1.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2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MP1-3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glecf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50-244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Pharmingen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R-β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57-59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R11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R11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03259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55942" y="708358"/>
            <a:ext cx="1927385" cy="1464263"/>
            <a:chOff x="355524" y="589535"/>
            <a:chExt cx="1927385" cy="146426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524" y="613798"/>
              <a:ext cx="1927385" cy="14400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55524" y="589535"/>
              <a:ext cx="40815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GB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2371388" y="669150"/>
            <a:ext cx="1945549" cy="1503471"/>
            <a:chOff x="2370970" y="550327"/>
            <a:chExt cx="1945549" cy="150347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9134" y="613798"/>
              <a:ext cx="1927385" cy="14400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370970" y="550327"/>
              <a:ext cx="40815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GB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4439831" y="637411"/>
            <a:ext cx="408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327724" y="2495014"/>
            <a:ext cx="1927385" cy="1455827"/>
            <a:chOff x="355523" y="2156460"/>
            <a:chExt cx="1927385" cy="1455827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523" y="2172287"/>
              <a:ext cx="1927385" cy="144000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355524" y="2156460"/>
              <a:ext cx="40815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GB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2343170" y="2510841"/>
            <a:ext cx="1927386" cy="1440000"/>
            <a:chOff x="2370969" y="2172287"/>
            <a:chExt cx="1927386" cy="1440000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70970" y="2172287"/>
              <a:ext cx="1927385" cy="144000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2370969" y="2172287"/>
              <a:ext cx="40815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GB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4469169" y="2441990"/>
            <a:ext cx="408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)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8587807"/>
              </p:ext>
            </p:extLst>
          </p:nvPr>
        </p:nvGraphicFramePr>
        <p:xfrm>
          <a:off x="4643438" y="525463"/>
          <a:ext cx="2057400" cy="1963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269" name="Prism 6" r:id="rId8" imgW="2057400" imgH="1964160" progId="Prism6.Document">
                  <p:embed/>
                </p:oleObj>
              </mc:Choice>
              <mc:Fallback>
                <p:oleObj name="Prism 6" r:id="rId8" imgW="2057400" imgH="19641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43438" y="525463"/>
                        <a:ext cx="2057400" cy="1963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445393" y="6110333"/>
            <a:ext cx="5936357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9: Therapeutic ICOS-L blockade does not alter mucus hyper-secretion, collagen deposition or airway smooth muscle thickening. 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were expose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(i.n) to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25 µ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ouse dust mite (HDM), 10 µg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alternaria alternata 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) or 25 µl phosphate buffered saline (PBS), 3 times a week for 5 weeks. From the start of week 4 mice were also administered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150 µ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body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. Mice were culled at the end of week 5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-B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images of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eriodic Acid-Schiff (PAS) staining on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parafilm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embedded formalin fixed (PEFF) lung sections used to score mucus hyper-secretion.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IgG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, B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+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, C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Quantification of PAS scoring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D-E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staining of Pico-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Siru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Red on PEFF lung used to determine collagen I and III deposition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IgG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, E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DM+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otal collagen in the lungs determined by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Sircol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soluble collagen assay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G-H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taining of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irway smooth muscle cells and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myofibroblast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identified by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mmunohistochemical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staining of 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smooth muscle actin (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SMA)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G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DM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IgG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, H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DM+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I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irway smooth muscle layer thickness was measured from 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SMA stained sections.  Images were taken at x20 magnification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tatistical significance was determined using a Mann Whitney U test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Data i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pooled from two independent experiments, n=8 for PBS treated groups, n=12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2554146"/>
              </p:ext>
            </p:extLst>
          </p:nvPr>
        </p:nvGraphicFramePr>
        <p:xfrm>
          <a:off x="4619625" y="2290763"/>
          <a:ext cx="2081213" cy="1978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270" name="Prism 6" r:id="rId10" imgW="2081520" imgH="1977840" progId="Prism6.Document">
                  <p:embed/>
                </p:oleObj>
              </mc:Choice>
              <mc:Fallback>
                <p:oleObj name="Prism 6" r:id="rId10" imgW="2081520" imgH="19778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19625" y="2290763"/>
                        <a:ext cx="2081213" cy="1978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4" name="Content Placeholder 3"/>
          <p:cNvPicPr>
            <a:picLocks noGrp="1" noChangeAspect="1"/>
          </p:cNvPicPr>
          <p:nvPr>
            <p:ph idx="1"/>
          </p:nvPr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22" y="4289061"/>
            <a:ext cx="1927385" cy="1440000"/>
          </a:xfr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553" y="4275819"/>
            <a:ext cx="1927385" cy="1440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3422" y="4275819"/>
            <a:ext cx="42067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389552" y="4275819"/>
            <a:ext cx="49879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3123440"/>
              </p:ext>
            </p:extLst>
          </p:nvPr>
        </p:nvGraphicFramePr>
        <p:xfrm>
          <a:off x="4506913" y="4100513"/>
          <a:ext cx="2198687" cy="1978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271" name="Prism 6" r:id="rId14" imgW="2198880" imgH="1977840" progId="Prism6.Document">
                  <p:embed/>
                </p:oleObj>
              </mc:Choice>
              <mc:Fallback>
                <p:oleObj name="Prism 6" r:id="rId14" imgW="2198880" imgH="19778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506913" y="4100513"/>
                        <a:ext cx="2198687" cy="1978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4508968" y="4191454"/>
            <a:ext cx="4081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525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593704" y="2710079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46794" y="496048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581281" y="2710079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59275" y="2758354"/>
            <a:ext cx="1994349" cy="2151503"/>
            <a:chOff x="616333" y="685700"/>
            <a:chExt cx="1994349" cy="2151503"/>
          </a:xfrm>
        </p:grpSpPr>
        <p:grpSp>
          <p:nvGrpSpPr>
            <p:cNvPr id="4" name="Group 3"/>
            <p:cNvGrpSpPr/>
            <p:nvPr/>
          </p:nvGrpSpPr>
          <p:grpSpPr>
            <a:xfrm>
              <a:off x="616333" y="685700"/>
              <a:ext cx="1994349" cy="2151503"/>
              <a:chOff x="356097" y="617904"/>
              <a:chExt cx="1994349" cy="2151503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311478" y="1693073"/>
                <a:ext cx="5767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endParaRPr lang="en-GB" sz="1100" b="1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434052" y="2316408"/>
                <a:ext cx="5655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-13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>
                <a:off x="871021" y="1823878"/>
                <a:ext cx="468000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819379" y="854407"/>
                <a:ext cx="78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gG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343504" y="854407"/>
                <a:ext cx="10069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Symbol" panose="05050102010706020507" pitchFamily="18" charset="2"/>
                    <a:cs typeface="Times New Roman" panose="02020603050405020304" pitchFamily="18" charset="0"/>
                  </a:rPr>
                  <a:t>a</a:t>
                </a:r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ICOS-L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1184275" y="617904"/>
                <a:ext cx="78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1209610" y="849796"/>
                <a:ext cx="72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/>
              <p:nvPr/>
            </p:nvCxnSpPr>
            <p:spPr>
              <a:xfrm flipV="1">
                <a:off x="824275" y="2113550"/>
                <a:ext cx="0" cy="540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356097" y="1028184"/>
                <a:ext cx="5767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 cells</a:t>
                </a:r>
                <a:endParaRPr lang="en-GB" sz="1100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34159" y="1845874"/>
                <a:ext cx="5767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Cs</a:t>
                </a:r>
                <a:endParaRPr lang="en-GB" sz="1100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871021" y="2507797"/>
                <a:ext cx="1000880" cy="261610"/>
                <a:chOff x="4655428" y="817848"/>
                <a:chExt cx="1000880" cy="261610"/>
              </a:xfrm>
            </p:grpSpPr>
            <p:sp>
              <p:nvSpPr>
                <p:cNvPr id="20" name="TextBox 19"/>
                <p:cNvSpPr txBox="1"/>
                <p:nvPr/>
              </p:nvSpPr>
              <p:spPr>
                <a:xfrm>
                  <a:off x="5079580" y="817848"/>
                  <a:ext cx="57672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5</a:t>
                  </a:r>
                  <a:endParaRPr lang="en-GB" sz="1100" b="1" dirty="0">
                    <a:latin typeface="Symbol" panose="05050102010706020507" pitchFamily="18" charset="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1" name="Straight Arrow Connector 20"/>
                <p:cNvCxnSpPr/>
                <p:nvPr/>
              </p:nvCxnSpPr>
              <p:spPr>
                <a:xfrm>
                  <a:off x="4655428" y="950681"/>
                  <a:ext cx="468000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79615" y="1112866"/>
              <a:ext cx="720000" cy="7200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76875" y="1112866"/>
              <a:ext cx="720000" cy="7200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79615" y="1936125"/>
              <a:ext cx="720000" cy="7200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76875" y="1936125"/>
              <a:ext cx="720000" cy="720000"/>
            </a:xfrm>
            <a:prstGeom prst="rect">
              <a:avLst/>
            </a:prstGeom>
          </p:spPr>
        </p:pic>
      </p:grpSp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4032036"/>
              </p:ext>
            </p:extLst>
          </p:nvPr>
        </p:nvGraphicFramePr>
        <p:xfrm>
          <a:off x="2578161" y="2990850"/>
          <a:ext cx="194035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3" name="Prism 6" r:id="rId7" imgW="2128680" imgH="1974960" progId="Prism6.Document">
                  <p:embed/>
                </p:oleObj>
              </mc:Choice>
              <mc:Fallback>
                <p:oleObj name="Prism 6" r:id="rId7" imgW="2128680" imgH="19749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78161" y="2990850"/>
                        <a:ext cx="194035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1328015"/>
              </p:ext>
            </p:extLst>
          </p:nvPr>
        </p:nvGraphicFramePr>
        <p:xfrm>
          <a:off x="535703" y="5067371"/>
          <a:ext cx="1940241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4" name="Prism 6" r:id="rId9" imgW="2130480" imgH="1976400" progId="Prism6.Document">
                  <p:embed/>
                </p:oleObj>
              </mc:Choice>
              <mc:Fallback>
                <p:oleObj name="Prism 6" r:id="rId9" imgW="2130480" imgH="197640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35703" y="5067371"/>
                        <a:ext cx="1940241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3871143"/>
              </p:ext>
            </p:extLst>
          </p:nvPr>
        </p:nvGraphicFramePr>
        <p:xfrm>
          <a:off x="2504203" y="5067371"/>
          <a:ext cx="1937681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5" name="Prism 6" r:id="rId11" imgW="2122920" imgH="1971720" progId="Prism6.Document">
                  <p:embed/>
                </p:oleObj>
              </mc:Choice>
              <mc:Fallback>
                <p:oleObj name="Prism 6" r:id="rId11" imgW="2122920" imgH="19717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04203" y="5067371"/>
                        <a:ext cx="1937681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/>
          <p:cNvSpPr txBox="1"/>
          <p:nvPr/>
        </p:nvSpPr>
        <p:spPr>
          <a:xfrm>
            <a:off x="535703" y="7000334"/>
            <a:ext cx="576346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igure S10: IL-13</a:t>
            </a:r>
            <a:r>
              <a:rPr lang="en-GB" sz="10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T cells are reduced by ICOS-L blockade in alternaria alternate driven allergic airway disease. </a:t>
            </a:r>
          </a:p>
          <a:p>
            <a:pPr algn="just">
              <a:defRPr/>
            </a:pP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were exposed to either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25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µg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ouse dust mite (HDM), 10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µg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alternaria alternata 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) or 25 µl phosphate buffered saline (PB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 for up to 5 weeks. From the start of week 4 mice were also administered 150 µg 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body (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) 3 times a week. Mice were culled at the end of week 5. Flow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ytometry was used to determine the frequency of lung cellular population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 study data – Total lung ILCs as a proportion of CD45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cell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-E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ernaria study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)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Total lung ILC proportions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otal number of ILCs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gatin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f IL-13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T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ells and IL-1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ILCs following HDM an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r 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reatment. Data is quantified for all groups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roportions of lung IL-1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T cells and ILCs.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s of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lung IL-13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T cells and ILCs. Experiment was performed once. n=4 for PBS treated groups, n=6 for ALT treated groups.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1432180"/>
              </p:ext>
            </p:extLst>
          </p:nvPr>
        </p:nvGraphicFramePr>
        <p:xfrm>
          <a:off x="4332689" y="2965996"/>
          <a:ext cx="1886886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6" name="Prism 6" r:id="rId13" imgW="1961280" imgH="1871280" progId="Prism6.Document">
                  <p:embed/>
                </p:oleObj>
              </mc:Choice>
              <mc:Fallback>
                <p:oleObj name="Prism 6" r:id="rId13" imgW="1961280" imgH="18712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332689" y="2965996"/>
                        <a:ext cx="1886886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583554" y="649086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0497808"/>
              </p:ext>
            </p:extLst>
          </p:nvPr>
        </p:nvGraphicFramePr>
        <p:xfrm>
          <a:off x="458044" y="804403"/>
          <a:ext cx="193069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7" name="Prism 6" r:id="rId15" imgW="2368080" imgH="2208240" progId="Prism6.Document">
                  <p:embed/>
                </p:oleObj>
              </mc:Choice>
              <mc:Fallback>
                <p:oleObj name="Prism 6" r:id="rId15" imgW="2368080" imgH="22082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58044" y="804403"/>
                        <a:ext cx="193069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1309405"/>
              </p:ext>
            </p:extLst>
          </p:nvPr>
        </p:nvGraphicFramePr>
        <p:xfrm>
          <a:off x="3332074" y="804403"/>
          <a:ext cx="193069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8" name="Prism 6" r:id="rId17" imgW="2368080" imgH="2208240" progId="Prism6.Document">
                  <p:embed/>
                </p:oleObj>
              </mc:Choice>
              <mc:Fallback>
                <p:oleObj name="Prism 6" r:id="rId17" imgW="2368080" imgH="22082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332074" y="804403"/>
                        <a:ext cx="193069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0921841"/>
              </p:ext>
            </p:extLst>
          </p:nvPr>
        </p:nvGraphicFramePr>
        <p:xfrm>
          <a:off x="4784791" y="804403"/>
          <a:ext cx="193069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69" name="Prism 6" r:id="rId19" imgW="2368080" imgH="2208240" progId="Prism6.Document">
                  <p:embed/>
                </p:oleObj>
              </mc:Choice>
              <mc:Fallback>
                <p:oleObj name="Prism 6" r:id="rId19" imgW="2368080" imgH="22082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84791" y="804403"/>
                        <a:ext cx="193069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/>
          <p:cNvSpPr txBox="1"/>
          <p:nvPr/>
        </p:nvSpPr>
        <p:spPr>
          <a:xfrm>
            <a:off x="3419283" y="622672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6" name="Objec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2987787"/>
              </p:ext>
            </p:extLst>
          </p:nvPr>
        </p:nvGraphicFramePr>
        <p:xfrm>
          <a:off x="1910761" y="804403"/>
          <a:ext cx="189929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7570" name="Prism 6" r:id="rId21" imgW="2368080" imgH="2244600" progId="Prism6.Document">
                  <p:embed/>
                </p:oleObj>
              </mc:Choice>
              <mc:Fallback>
                <p:oleObj name="Prism 6" r:id="rId21" imgW="2368080" imgH="224460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910761" y="804403"/>
                        <a:ext cx="189929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56917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TextBox 92"/>
          <p:cNvSpPr txBox="1"/>
          <p:nvPr/>
        </p:nvSpPr>
        <p:spPr>
          <a:xfrm>
            <a:off x="597726" y="55255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515904" y="267852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478141" y="731882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2" name="Object 1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8881504"/>
              </p:ext>
            </p:extLst>
          </p:nvPr>
        </p:nvGraphicFramePr>
        <p:xfrm>
          <a:off x="3395663" y="903765"/>
          <a:ext cx="1885950" cy="178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1" name="Prism 6" r:id="rId4" imgW="2144160" imgH="2032920" progId="Prism6.Document">
                  <p:embed/>
                </p:oleObj>
              </mc:Choice>
              <mc:Fallback>
                <p:oleObj name="Prism 6" r:id="rId4" imgW="2144160" imgH="20329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95663" y="903765"/>
                        <a:ext cx="1885950" cy="1787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" name="Object 1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7398025"/>
              </p:ext>
            </p:extLst>
          </p:nvPr>
        </p:nvGraphicFramePr>
        <p:xfrm>
          <a:off x="4786313" y="920846"/>
          <a:ext cx="1966912" cy="1787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2" name="Prism 6" r:id="rId6" imgW="2160720" imgH="1964160" progId="Prism6.Document">
                  <p:embed/>
                </p:oleObj>
              </mc:Choice>
              <mc:Fallback>
                <p:oleObj name="Prism 6" r:id="rId6" imgW="2160720" imgH="19641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86313" y="920846"/>
                        <a:ext cx="1966912" cy="1787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7" name="TextBox 136"/>
          <p:cNvSpPr txBox="1"/>
          <p:nvPr/>
        </p:nvSpPr>
        <p:spPr>
          <a:xfrm>
            <a:off x="3376111" y="267852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4" name="Object 1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3735883"/>
              </p:ext>
            </p:extLst>
          </p:nvPr>
        </p:nvGraphicFramePr>
        <p:xfrm>
          <a:off x="457315" y="2836349"/>
          <a:ext cx="1897062" cy="1789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3" name="Prism 6" r:id="rId8" imgW="2145600" imgH="2022120" progId="Prism6.Document">
                  <p:embed/>
                </p:oleObj>
              </mc:Choice>
              <mc:Fallback>
                <p:oleObj name="Prism 6" r:id="rId8" imgW="2145600" imgH="2022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57315" y="2836349"/>
                        <a:ext cx="1897062" cy="1789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5" name="Object 1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6096061"/>
              </p:ext>
            </p:extLst>
          </p:nvPr>
        </p:nvGraphicFramePr>
        <p:xfrm>
          <a:off x="1861685" y="2859407"/>
          <a:ext cx="1920875" cy="1789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4" name="Prism 6" r:id="rId10" imgW="2108880" imgH="1964160" progId="Prism6.Document">
                  <p:embed/>
                </p:oleObj>
              </mc:Choice>
              <mc:Fallback>
                <p:oleObj name="Prism 6" r:id="rId10" imgW="2108880" imgH="19641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61685" y="2859407"/>
                        <a:ext cx="1920875" cy="1789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TextBox 138"/>
          <p:cNvSpPr txBox="1"/>
          <p:nvPr/>
        </p:nvSpPr>
        <p:spPr>
          <a:xfrm>
            <a:off x="475833" y="6356533"/>
            <a:ext cx="5839659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igure S11: IL-17A</a:t>
            </a:r>
            <a:r>
              <a:rPr lang="en-GB" sz="10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T cells are not directly targeted by ICOS-L blockade</a:t>
            </a:r>
          </a:p>
          <a:p>
            <a:pPr algn="just">
              <a:defRPr/>
            </a:pP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dult female BALB/c mice were exposed to either 25 µg house dust mite (HDM), 10 µg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alternaria alternata 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) or 25 µl phosphate buffered saline (PB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 for up to 5 weeks. Flow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ytometry was used to determine the frequency of lung cellular population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gatin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f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T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ells and IL-17A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ILCs following allergen an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r 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reatment. These populations were quantified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roportions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- HDM study,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 of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lung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- HDM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tudy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, D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roportion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-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study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E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Number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-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study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Proportions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C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 HDM study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G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Proportions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C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tudy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H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Number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C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tudy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I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Number of lung IL-17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LCs -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 study,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Statistical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ignificance was determined using a Mann Whitney U test. 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01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HDM data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s pooled from two independent experiments, n=8 for PBS treated groups, n=12 for HDM treated groups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experimen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was performed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once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n=4 for PBS treated groups, n=6 for ALT treated groups.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11922" y="579276"/>
            <a:ext cx="3080888" cy="2126572"/>
            <a:chOff x="511923" y="598011"/>
            <a:chExt cx="3080888" cy="2126572"/>
          </a:xfrm>
        </p:grpSpPr>
        <p:sp>
          <p:nvSpPr>
            <p:cNvPr id="25" name="TextBox 24"/>
            <p:cNvSpPr txBox="1"/>
            <p:nvPr/>
          </p:nvSpPr>
          <p:spPr>
            <a:xfrm>
              <a:off x="1121273" y="1678613"/>
              <a:ext cx="5767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lang="en-GB" sz="1100" dirty="0">
                <a:latin typeface="Symbol" panose="05050102010706020507" pitchFamily="18" charset="2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280991" y="2097549"/>
              <a:ext cx="7234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17A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810015" y="1809418"/>
              <a:ext cx="360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728218" y="864818"/>
              <a:ext cx="7804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G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219450" y="864818"/>
              <a:ext cx="10069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ICOS-L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070096" y="601670"/>
              <a:ext cx="7804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DM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1070096" y="857681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 flipV="1">
              <a:off x="769314" y="2190535"/>
              <a:ext cx="0" cy="3600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2094637" y="864818"/>
              <a:ext cx="7804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G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585869" y="864818"/>
              <a:ext cx="10069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Symbol" panose="05050102010706020507" pitchFamily="18" charset="2"/>
                  <a:cs typeface="Times New Roman" panose="02020603050405020304" pitchFamily="18" charset="0"/>
                </a:rPr>
                <a:t>a</a:t>
              </a:r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ICOS-L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436515" y="598011"/>
              <a:ext cx="7804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T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2436515" y="854022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4" name="Picture 7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735274" y="1020368"/>
              <a:ext cx="720000" cy="720000"/>
            </a:xfrm>
            <a:prstGeom prst="rect">
              <a:avLst/>
            </a:prstGeom>
          </p:spPr>
        </p:pic>
        <p:pic>
          <p:nvPicPr>
            <p:cNvPr id="75" name="Picture 7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414956" y="1022152"/>
              <a:ext cx="720000" cy="720000"/>
            </a:xfrm>
            <a:prstGeom prst="rect">
              <a:avLst/>
            </a:prstGeom>
          </p:spPr>
        </p:pic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140759" y="1074335"/>
              <a:ext cx="666000" cy="666000"/>
            </a:xfrm>
            <a:prstGeom prst="rect">
              <a:avLst/>
            </a:prstGeom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801985" y="1074368"/>
              <a:ext cx="666000" cy="666000"/>
            </a:xfrm>
            <a:prstGeom prst="rect">
              <a:avLst/>
            </a:prstGeom>
          </p:spPr>
        </p:pic>
        <p:grpSp>
          <p:nvGrpSpPr>
            <p:cNvPr id="33" name="Group 32"/>
            <p:cNvGrpSpPr/>
            <p:nvPr/>
          </p:nvGrpSpPr>
          <p:grpSpPr>
            <a:xfrm>
              <a:off x="770791" y="1852704"/>
              <a:ext cx="2697194" cy="871879"/>
              <a:chOff x="1252839" y="-2224090"/>
              <a:chExt cx="2697194" cy="871879"/>
            </a:xfrm>
          </p:grpSpPr>
          <p:sp>
            <p:nvSpPr>
              <p:cNvPr id="44" name="TextBox 43"/>
              <p:cNvSpPr txBox="1"/>
              <p:nvPr/>
            </p:nvSpPr>
            <p:spPr>
              <a:xfrm>
                <a:off x="1569627" y="-1613821"/>
                <a:ext cx="5767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5</a:t>
                </a:r>
                <a:endParaRPr lang="en-GB" sz="1100" dirty="0">
                  <a:latin typeface="Symbol" panose="05050102010706020507" pitchFamily="18" charset="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5" name="Straight Arrow Connector 44"/>
              <p:cNvCxnSpPr/>
              <p:nvPr/>
            </p:nvCxnSpPr>
            <p:spPr>
              <a:xfrm>
                <a:off x="1271156" y="-1480988"/>
                <a:ext cx="360000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46" name="Picture 45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252839" y="-2219630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47" name="Picture 46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932416" y="-2219630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48" name="Picture 47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2618451" y="-2219630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49" name="Picture 48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284033" y="-2224090"/>
                <a:ext cx="666000" cy="666000"/>
              </a:xfrm>
              <a:prstGeom prst="rect">
                <a:avLst/>
              </a:prstGeom>
            </p:spPr>
          </p:pic>
        </p:grpSp>
      </p:grpSp>
      <p:sp>
        <p:nvSpPr>
          <p:cNvPr id="52" name="TextBox 51"/>
          <p:cNvSpPr txBox="1"/>
          <p:nvPr/>
        </p:nvSpPr>
        <p:spPr>
          <a:xfrm>
            <a:off x="1901916" y="267852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806530" y="2678523"/>
            <a:ext cx="4310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41253" y="4545108"/>
            <a:ext cx="404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7" name="Objec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3827652"/>
              </p:ext>
            </p:extLst>
          </p:nvPr>
        </p:nvGraphicFramePr>
        <p:xfrm>
          <a:off x="382985" y="4633405"/>
          <a:ext cx="194885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5" name="Prism 6" r:id="rId20" imgW="2140920" imgH="1974960" progId="Prism6.Document">
                  <p:embed/>
                </p:oleObj>
              </mc:Choice>
              <mc:Fallback>
                <p:oleObj name="Prism 6" r:id="rId20" imgW="2140920" imgH="19749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82985" y="4633405"/>
                        <a:ext cx="194885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6839590"/>
              </p:ext>
            </p:extLst>
          </p:nvPr>
        </p:nvGraphicFramePr>
        <p:xfrm>
          <a:off x="3289868" y="2788812"/>
          <a:ext cx="1989137" cy="1858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6" name="Prism 6" r:id="rId22" imgW="1988640" imgH="1859040" progId="Prism6.Document">
                  <p:embed/>
                </p:oleObj>
              </mc:Choice>
              <mc:Fallback>
                <p:oleObj name="Prism 6" r:id="rId22" imgW="1988640" imgH="18590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289868" y="2788812"/>
                        <a:ext cx="1989137" cy="1858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5105923"/>
              </p:ext>
            </p:extLst>
          </p:nvPr>
        </p:nvGraphicFramePr>
        <p:xfrm>
          <a:off x="1903361" y="4625065"/>
          <a:ext cx="1953454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7" name="Prism 6" r:id="rId24" imgW="2125800" imgH="1958040" progId="Prism6.Document">
                  <p:embed/>
                </p:oleObj>
              </mc:Choice>
              <mc:Fallback>
                <p:oleObj name="Prism 6" r:id="rId24" imgW="2125800" imgH="19580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903361" y="4625065"/>
                        <a:ext cx="1953454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8065350"/>
              </p:ext>
            </p:extLst>
          </p:nvPr>
        </p:nvGraphicFramePr>
        <p:xfrm>
          <a:off x="4786313" y="2808388"/>
          <a:ext cx="1957388" cy="1858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1788" name="Prism 6" r:id="rId26" imgW="1956600" imgH="1859040" progId="Prism6.Document">
                  <p:embed/>
                </p:oleObj>
              </mc:Choice>
              <mc:Fallback>
                <p:oleObj name="Prism 6" r:id="rId26" imgW="1956600" imgH="18590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786313" y="2808388"/>
                        <a:ext cx="1957388" cy="1858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" name="TextBox 60"/>
          <p:cNvSpPr txBox="1"/>
          <p:nvPr/>
        </p:nvSpPr>
        <p:spPr>
          <a:xfrm>
            <a:off x="4761223" y="731882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999581" y="4545108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3266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696632" y="552551"/>
            <a:ext cx="1853114" cy="2087013"/>
            <a:chOff x="1979365" y="554471"/>
            <a:chExt cx="1853114" cy="2087013"/>
          </a:xfrm>
        </p:grpSpPr>
        <p:grpSp>
          <p:nvGrpSpPr>
            <p:cNvPr id="5" name="Group 4"/>
            <p:cNvGrpSpPr/>
            <p:nvPr/>
          </p:nvGrpSpPr>
          <p:grpSpPr>
            <a:xfrm>
              <a:off x="2420671" y="554471"/>
              <a:ext cx="1411808" cy="519143"/>
              <a:chOff x="969314" y="449717"/>
              <a:chExt cx="1411808" cy="519143"/>
            </a:xfrm>
          </p:grpSpPr>
          <p:grpSp>
            <p:nvGrpSpPr>
              <p:cNvPr id="17" name="Group 6"/>
              <p:cNvGrpSpPr>
                <a:grpSpLocks/>
              </p:cNvGrpSpPr>
              <p:nvPr/>
            </p:nvGrpSpPr>
            <p:grpSpPr bwMode="auto">
              <a:xfrm>
                <a:off x="969314" y="710077"/>
                <a:ext cx="1411808" cy="258783"/>
                <a:chOff x="271394" y="428174"/>
                <a:chExt cx="1846680" cy="427530"/>
              </a:xfrm>
            </p:grpSpPr>
            <p:sp>
              <p:nvSpPr>
                <p:cNvPr id="20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271394" y="428174"/>
                  <a:ext cx="900565" cy="4194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algn="ctr"/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gG</a:t>
                  </a:r>
                  <a:endParaRPr lang="en-GB" altLang="en-US" sz="1050" i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1061792" y="436215"/>
                  <a:ext cx="1056282" cy="4194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algn="r"/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a</a:t>
                  </a:r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ICOS-L</a:t>
                  </a:r>
                  <a:endParaRPr lang="en-GB" altLang="en-US" sz="1050" i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8" name="TextBox 17"/>
              <p:cNvSpPr txBox="1"/>
              <p:nvPr/>
            </p:nvSpPr>
            <p:spPr>
              <a:xfrm rot="5400000">
                <a:off x="1628687" y="354008"/>
                <a:ext cx="346249" cy="53766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1256638" y="716297"/>
                <a:ext cx="900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/>
            <p:cNvGrpSpPr/>
            <p:nvPr/>
          </p:nvGrpSpPr>
          <p:grpSpPr>
            <a:xfrm>
              <a:off x="2089377" y="1236493"/>
              <a:ext cx="1255714" cy="1404991"/>
              <a:chOff x="1023291" y="4032327"/>
              <a:chExt cx="1255714" cy="1404991"/>
            </a:xfrm>
          </p:grpSpPr>
          <p:cxnSp>
            <p:nvCxnSpPr>
              <p:cNvPr id="13" name="Straight Arrow Connector 12"/>
              <p:cNvCxnSpPr/>
              <p:nvPr/>
            </p:nvCxnSpPr>
            <p:spPr>
              <a:xfrm>
                <a:off x="1268286" y="5189227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/>
              <p:nvPr/>
            </p:nvCxnSpPr>
            <p:spPr>
              <a:xfrm flipV="1">
                <a:off x="1277809" y="4726311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 rot="16200000">
                <a:off x="517003" y="4538615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xp3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363207" y="5175708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08749" y="949897"/>
              <a:ext cx="720000" cy="7200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80603" y="949897"/>
              <a:ext cx="720000" cy="720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09197" y="1617585"/>
              <a:ext cx="720000" cy="720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71806" y="1617585"/>
              <a:ext cx="720000" cy="720000"/>
            </a:xfrm>
            <a:prstGeom prst="rect">
              <a:avLst/>
            </a:prstGeom>
          </p:spPr>
        </p:pic>
        <p:sp>
          <p:nvSpPr>
            <p:cNvPr id="11" name="TextBox 1"/>
            <p:cNvSpPr txBox="1">
              <a:spLocks noChangeArrowheads="1"/>
            </p:cNvSpPr>
            <p:nvPr/>
          </p:nvSpPr>
          <p:spPr bwMode="auto">
            <a:xfrm>
              <a:off x="1984625" y="1629419"/>
              <a:ext cx="64451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9pPr>
            </a:lstStyle>
            <a:p>
              <a:r>
                <a:rPr lang="en-GB" altLang="en-US" sz="1100" i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ung</a:t>
              </a:r>
              <a:endParaRPr lang="en-GB" altLang="en-US" sz="1100" i="0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"/>
            <p:cNvSpPr txBox="1">
              <a:spLocks noChangeArrowheads="1"/>
            </p:cNvSpPr>
            <p:nvPr/>
          </p:nvSpPr>
          <p:spPr bwMode="auto">
            <a:xfrm>
              <a:off x="1979365" y="974883"/>
              <a:ext cx="64451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600" i="1">
                  <a:solidFill>
                    <a:srgbClr val="6E6E6F"/>
                  </a:solidFill>
                  <a:latin typeface="Verdana" panose="020B0604030504040204" pitchFamily="34" charset="0"/>
                  <a:ea typeface="MS PGothic" panose="020B0600070205080204" pitchFamily="34" charset="-128"/>
                </a:defRPr>
              </a:lvl9pPr>
            </a:lstStyle>
            <a:p>
              <a:r>
                <a:rPr lang="en-GB" altLang="en-US" sz="1100" i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GB" altLang="en-US" sz="1100" i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N</a:t>
              </a:r>
              <a:endParaRPr lang="en-GB" altLang="en-US" sz="1100" i="0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597726" y="55255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907357"/>
              </p:ext>
            </p:extLst>
          </p:nvPr>
        </p:nvGraphicFramePr>
        <p:xfrm>
          <a:off x="4275626" y="769267"/>
          <a:ext cx="196350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426" name="Prism 6" r:id="rId7" imgW="2192760" imgH="2009880" progId="Prism6.Document">
                  <p:embed/>
                </p:oleObj>
              </mc:Choice>
              <mc:Fallback>
                <p:oleObj name="Prism 6" r:id="rId7" imgW="2192760" imgH="20098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75626" y="769267"/>
                        <a:ext cx="196350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931050"/>
              </p:ext>
            </p:extLst>
          </p:nvPr>
        </p:nvGraphicFramePr>
        <p:xfrm>
          <a:off x="2601601" y="769267"/>
          <a:ext cx="190094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427" name="Prism 6" r:id="rId9" imgW="2122920" imgH="2009880" progId="Prism6.Document">
                  <p:embed/>
                </p:oleObj>
              </mc:Choice>
              <mc:Fallback>
                <p:oleObj name="Prism 6" r:id="rId9" imgW="2122920" imgH="20098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01601" y="769267"/>
                        <a:ext cx="190094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2601601" y="571787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29650" y="2825259"/>
            <a:ext cx="570948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12: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Therapeutic ICOS-L blockade reduces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T regulatory cells during Alternaria alternate driven allergic disease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were exposed (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i.n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) to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10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µg Alternaria 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Alternata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(ALT) or 25 µl phosphate buffered saline (PBS), 3 times a week for 5 weeks. From the start of week 4 mice were also administered 150 µg 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(IgG) antibody (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) 3 times a week. Mice were culled at the end of week 5. Flow cytometry was used to determine th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 of Foxp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T cells within the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mLN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and lung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flow cytometry of Foxp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cells in allergen treated mice given IgG or 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. Pre-gated on 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 cell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s of mLN and lung Foxp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T cells wer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quantified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tatistical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ignificance was determined using a Mann Whitney U test. 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01.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experiment was performed once, n=4 for PBS treated groups, n=6 for ALT treated groups.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3713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3" name="Group 122"/>
          <p:cNvGrpSpPr/>
          <p:nvPr/>
        </p:nvGrpSpPr>
        <p:grpSpPr>
          <a:xfrm>
            <a:off x="477273" y="689645"/>
            <a:ext cx="5923215" cy="3080899"/>
            <a:chOff x="477273" y="689645"/>
            <a:chExt cx="5923215" cy="3080899"/>
          </a:xfrm>
        </p:grpSpPr>
        <p:grpSp>
          <p:nvGrpSpPr>
            <p:cNvPr id="78" name="Group 77"/>
            <p:cNvGrpSpPr/>
            <p:nvPr/>
          </p:nvGrpSpPr>
          <p:grpSpPr>
            <a:xfrm>
              <a:off x="477273" y="689645"/>
              <a:ext cx="1274415" cy="1393744"/>
              <a:chOff x="354612" y="689645"/>
              <a:chExt cx="1274415" cy="1393744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25745" y="88360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13" name="Group 12"/>
              <p:cNvGrpSpPr/>
              <p:nvPr/>
            </p:nvGrpSpPr>
            <p:grpSpPr>
              <a:xfrm>
                <a:off x="354612" y="689645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30" name="Straight Arrow Connector 29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Arrow Connector 30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TextBox 31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V Live dead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7" name="Group 76"/>
            <p:cNvGrpSpPr/>
            <p:nvPr/>
          </p:nvGrpSpPr>
          <p:grpSpPr>
            <a:xfrm>
              <a:off x="1639473" y="689645"/>
              <a:ext cx="1274415" cy="1393744"/>
              <a:chOff x="1562257" y="689645"/>
              <a:chExt cx="1274415" cy="1393744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845766" y="88360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34" name="Group 33"/>
              <p:cNvGrpSpPr/>
              <p:nvPr/>
            </p:nvGrpSpPr>
            <p:grpSpPr>
              <a:xfrm>
                <a:off x="1562257" y="689645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35" name="Straight Arrow Connector 34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TextBox 36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W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6" name="Group 75"/>
            <p:cNvGrpSpPr/>
            <p:nvPr/>
          </p:nvGrpSpPr>
          <p:grpSpPr>
            <a:xfrm>
              <a:off x="2801673" y="689645"/>
              <a:ext cx="1274415" cy="1393744"/>
              <a:chOff x="2753477" y="689645"/>
              <a:chExt cx="1274415" cy="1393744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016225" y="88360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39" name="Group 38"/>
              <p:cNvGrpSpPr/>
              <p:nvPr/>
            </p:nvGrpSpPr>
            <p:grpSpPr>
              <a:xfrm>
                <a:off x="2753477" y="689645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40" name="Straight Arrow Connector 39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Arrow Connector 40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W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5" name="Group 74"/>
            <p:cNvGrpSpPr/>
            <p:nvPr/>
          </p:nvGrpSpPr>
          <p:grpSpPr>
            <a:xfrm>
              <a:off x="3963873" y="689645"/>
              <a:ext cx="1274415" cy="1393744"/>
              <a:chOff x="3984561" y="689645"/>
              <a:chExt cx="1274415" cy="1393744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55107" y="88360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44" name="Group 43"/>
              <p:cNvGrpSpPr/>
              <p:nvPr/>
            </p:nvGrpSpPr>
            <p:grpSpPr>
              <a:xfrm>
                <a:off x="3984561" y="689645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45" name="Straight Arrow Connector 44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Arrow Connector 45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TextBox 46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4" name="Group 73"/>
            <p:cNvGrpSpPr/>
            <p:nvPr/>
          </p:nvGrpSpPr>
          <p:grpSpPr>
            <a:xfrm>
              <a:off x="5126073" y="689645"/>
              <a:ext cx="1274415" cy="1393744"/>
              <a:chOff x="5126073" y="689645"/>
              <a:chExt cx="1274415" cy="1393744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387683" y="88360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49" name="Group 48"/>
              <p:cNvGrpSpPr/>
              <p:nvPr/>
            </p:nvGrpSpPr>
            <p:grpSpPr>
              <a:xfrm>
                <a:off x="5126073" y="689645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50" name="Straight Arrow Connector 49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Arrow Connector 50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TextBox 51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9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82" name="Group 81"/>
            <p:cNvGrpSpPr/>
            <p:nvPr/>
          </p:nvGrpSpPr>
          <p:grpSpPr>
            <a:xfrm>
              <a:off x="790351" y="2376800"/>
              <a:ext cx="1274415" cy="1393744"/>
              <a:chOff x="790351" y="2376800"/>
              <a:chExt cx="1274415" cy="1393744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68982" y="256389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54" name="Group 53"/>
              <p:cNvGrpSpPr/>
              <p:nvPr/>
            </p:nvGrpSpPr>
            <p:grpSpPr>
              <a:xfrm>
                <a:off x="790351" y="2376800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55" name="Straight Arrow Connector 54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Arrow Connector 55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8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81" name="Group 80"/>
            <p:cNvGrpSpPr/>
            <p:nvPr/>
          </p:nvGrpSpPr>
          <p:grpSpPr>
            <a:xfrm>
              <a:off x="2030664" y="2376800"/>
              <a:ext cx="1274415" cy="1393744"/>
              <a:chOff x="2088546" y="2376800"/>
              <a:chExt cx="1274415" cy="1393744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366854" y="256389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59" name="Group 58"/>
              <p:cNvGrpSpPr/>
              <p:nvPr/>
            </p:nvGrpSpPr>
            <p:grpSpPr>
              <a:xfrm>
                <a:off x="2088546" y="2376800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60" name="Straight Arrow Connector 59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Straight Arrow Connector 60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61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oxp3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80" name="Group 79"/>
            <p:cNvGrpSpPr/>
            <p:nvPr/>
          </p:nvGrpSpPr>
          <p:grpSpPr>
            <a:xfrm>
              <a:off x="3270977" y="2376800"/>
              <a:ext cx="1274415" cy="1393744"/>
              <a:chOff x="3306666" y="2376800"/>
              <a:chExt cx="1274415" cy="1393744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590175" y="256389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64" name="Group 63"/>
              <p:cNvGrpSpPr/>
              <p:nvPr/>
            </p:nvGrpSpPr>
            <p:grpSpPr>
              <a:xfrm>
                <a:off x="3306666" y="2376800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65" name="Straight Arrow Connector 64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Arrow Connector 65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TextBox 66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4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62L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9" name="Group 78"/>
            <p:cNvGrpSpPr/>
            <p:nvPr/>
          </p:nvGrpSpPr>
          <p:grpSpPr>
            <a:xfrm>
              <a:off x="4511290" y="2376800"/>
              <a:ext cx="1274415" cy="1393744"/>
              <a:chOff x="4511290" y="2376800"/>
              <a:chExt cx="1274415" cy="1393744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84509" y="2563893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69" name="Group 68"/>
              <p:cNvGrpSpPr/>
              <p:nvPr/>
            </p:nvGrpSpPr>
            <p:grpSpPr>
              <a:xfrm>
                <a:off x="4511290" y="2376800"/>
                <a:ext cx="1274415" cy="1393744"/>
                <a:chOff x="1015881" y="1711446"/>
                <a:chExt cx="1274415" cy="1393744"/>
              </a:xfrm>
            </p:grpSpPr>
            <p:cxnSp>
              <p:nvCxnSpPr>
                <p:cNvPr id="70" name="Straight Arrow Connector 69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Arrow Connector 70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TextBox 71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XCR5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D1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01" name="Group 100"/>
            <p:cNvGrpSpPr/>
            <p:nvPr/>
          </p:nvGrpSpPr>
          <p:grpSpPr>
            <a:xfrm>
              <a:off x="1606867" y="1654198"/>
              <a:ext cx="4419656" cy="1103593"/>
              <a:chOff x="1606867" y="1654198"/>
              <a:chExt cx="4419656" cy="1103593"/>
            </a:xfrm>
          </p:grpSpPr>
          <p:cxnSp>
            <p:nvCxnSpPr>
              <p:cNvPr id="90" name="Straight Connector 89"/>
              <p:cNvCxnSpPr/>
              <p:nvPr/>
            </p:nvCxnSpPr>
            <p:spPr>
              <a:xfrm>
                <a:off x="6026523" y="1654198"/>
                <a:ext cx="0" cy="771241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 flipH="1">
                <a:off x="1606867" y="2415711"/>
                <a:ext cx="441965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Arrow Connector 98"/>
              <p:cNvCxnSpPr/>
              <p:nvPr/>
            </p:nvCxnSpPr>
            <p:spPr>
              <a:xfrm>
                <a:off x="1606867" y="2410847"/>
                <a:ext cx="0" cy="346944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3" name="Straight Arrow Connector 102"/>
            <p:cNvCxnSpPr/>
            <p:nvPr/>
          </p:nvCxnSpPr>
          <p:spPr>
            <a:xfrm>
              <a:off x="1670222" y="3007348"/>
              <a:ext cx="75851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/>
            <p:cNvCxnSpPr/>
            <p:nvPr/>
          </p:nvCxnSpPr>
          <p:spPr>
            <a:xfrm flipV="1">
              <a:off x="1410293" y="1259146"/>
              <a:ext cx="620370" cy="14225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Arrow Connector 106"/>
            <p:cNvCxnSpPr/>
            <p:nvPr/>
          </p:nvCxnSpPr>
          <p:spPr>
            <a:xfrm flipV="1">
              <a:off x="2475944" y="1284003"/>
              <a:ext cx="737874" cy="24041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Arrow Connector 108"/>
            <p:cNvCxnSpPr/>
            <p:nvPr/>
          </p:nvCxnSpPr>
          <p:spPr>
            <a:xfrm flipV="1">
              <a:off x="3720065" y="1277480"/>
              <a:ext cx="712046" cy="22434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Arrow Connector 112"/>
            <p:cNvCxnSpPr/>
            <p:nvPr/>
          </p:nvCxnSpPr>
          <p:spPr>
            <a:xfrm flipV="1">
              <a:off x="4695570" y="1201994"/>
              <a:ext cx="758512" cy="2998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Arrow Connector 114"/>
            <p:cNvCxnSpPr/>
            <p:nvPr/>
          </p:nvCxnSpPr>
          <p:spPr>
            <a:xfrm flipV="1">
              <a:off x="3029974" y="2890346"/>
              <a:ext cx="599620" cy="33550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/>
            <p:cNvCxnSpPr/>
            <p:nvPr/>
          </p:nvCxnSpPr>
          <p:spPr>
            <a:xfrm>
              <a:off x="4045185" y="2757791"/>
              <a:ext cx="82472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Rectangle 121"/>
            <p:cNvSpPr/>
            <p:nvPr/>
          </p:nvSpPr>
          <p:spPr>
            <a:xfrm>
              <a:off x="5109883" y="2614108"/>
              <a:ext cx="570156" cy="46795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4" name="TextBox 4"/>
          <p:cNvSpPr txBox="1"/>
          <p:nvPr/>
        </p:nvSpPr>
        <p:spPr>
          <a:xfrm>
            <a:off x="608078" y="4227138"/>
            <a:ext cx="56796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1: T follicular helper cell gating strategy</a:t>
            </a:r>
          </a:p>
          <a:p>
            <a:pPr algn="just"/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T follicular helper cells (T</a:t>
            </a:r>
            <a:r>
              <a:rPr lang="en-GB" sz="1000" baseline="-25000" dirty="0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were identified by flow cytometry and defined as CXCR5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D1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Foxp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hi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D62L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lymphocytes.</a:t>
            </a:r>
          </a:p>
          <a:p>
            <a:pPr algn="just"/>
            <a:endParaRPr lang="en-GB" sz="10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5110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580541" y="5637916"/>
            <a:ext cx="588242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igure S2: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GB" sz="1000" b="1" baseline="-25000" dirty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re induced in the spleen but not in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the circulation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ollowing allergen exposure. </a:t>
            </a:r>
          </a:p>
          <a:p>
            <a:pPr algn="just"/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dult female BALB/c mice were exposed to either 25 µg house dust mite (HDM), 10 µg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alternaria alternata 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) or 25 µl phosphate buffered saline (PB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 for up to 5 weeks. Flow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ytometry was used to determine the frequency of T</a:t>
            </a:r>
            <a:r>
              <a:rPr lang="en-GB" sz="1000" baseline="-25000" dirty="0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within cellular compartments following allergen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exposure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GB" sz="1000" baseline="-25000" dirty="0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were defined as CXCR5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D1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Foxp3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Representative flow plots of T</a:t>
            </a:r>
            <a:r>
              <a:rPr lang="en-GB" sz="1000" baseline="-25000" dirty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in PBS, ALT or HDM treated animals are displayed, pre-gated on CD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D3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oxp3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D44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hi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D62L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lymphocytes. Data is quantified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pleen,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Blood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. Statistical significance was determined using a Mann Whitney U test. 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n=5 per time-point. Representative data from 2 independent experiments. 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09028" y="62986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3447805"/>
              </p:ext>
            </p:extLst>
          </p:nvPr>
        </p:nvGraphicFramePr>
        <p:xfrm>
          <a:off x="3711313" y="898339"/>
          <a:ext cx="1773237" cy="2087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475" name="Prism 6" r:id="rId4" imgW="1773720" imgH="2087640" progId="Prism6.Document">
                  <p:embed/>
                </p:oleObj>
              </mc:Choice>
              <mc:Fallback>
                <p:oleObj name="Prism 6" r:id="rId4" imgW="1773720" imgH="20876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711313" y="898339"/>
                        <a:ext cx="1773237" cy="2087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7923131"/>
              </p:ext>
            </p:extLst>
          </p:nvPr>
        </p:nvGraphicFramePr>
        <p:xfrm>
          <a:off x="5049290" y="899927"/>
          <a:ext cx="1731963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476" name="Prism 6" r:id="rId6" imgW="1731240" imgH="2086200" progId="Prism6.Document">
                  <p:embed/>
                </p:oleObj>
              </mc:Choice>
              <mc:Fallback>
                <p:oleObj name="Prism 6" r:id="rId6" imgW="1731240" imgH="208620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049290" y="899927"/>
                        <a:ext cx="1731963" cy="208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57"/>
          <p:cNvSpPr txBox="1"/>
          <p:nvPr/>
        </p:nvSpPr>
        <p:spPr>
          <a:xfrm>
            <a:off x="2993681" y="945973"/>
            <a:ext cx="962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ek 5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5400000">
            <a:off x="1176086" y="2864641"/>
            <a:ext cx="353943" cy="665812"/>
          </a:xfrm>
          <a:prstGeom prst="rect">
            <a:avLst/>
          </a:prstGeom>
          <a:noFill/>
        </p:spPr>
        <p:txBody>
          <a:bodyPr vert="vert270" wrap="square" rtlCol="0">
            <a:spAutoFit/>
            <a:scene3d>
              <a:camera prst="orthographicFront">
                <a:rot lat="0" lon="0" rev="0"/>
              </a:camera>
              <a:lightRig rig="threePt" dir="t"/>
            </a:scene3d>
          </a:bodyPr>
          <a:lstStyle/>
          <a:p>
            <a:r>
              <a:rPr lang="en-GB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endParaRPr lang="en-GB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5063" y="304723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580541" y="3072890"/>
            <a:ext cx="3371527" cy="2182609"/>
            <a:chOff x="580541" y="3072890"/>
            <a:chExt cx="3371527" cy="2182609"/>
          </a:xfrm>
        </p:grpSpPr>
        <p:grpSp>
          <p:nvGrpSpPr>
            <p:cNvPr id="97" name="Group 96"/>
            <p:cNvGrpSpPr/>
            <p:nvPr/>
          </p:nvGrpSpPr>
          <p:grpSpPr>
            <a:xfrm>
              <a:off x="580541" y="3072890"/>
              <a:ext cx="3371527" cy="2182609"/>
              <a:chOff x="913076" y="922581"/>
              <a:chExt cx="3371527" cy="2182609"/>
            </a:xfrm>
          </p:grpSpPr>
          <p:sp>
            <p:nvSpPr>
              <p:cNvPr id="98" name="TextBox 97"/>
              <p:cNvSpPr txBox="1"/>
              <p:nvPr/>
            </p:nvSpPr>
            <p:spPr>
              <a:xfrm>
                <a:off x="1404492" y="1213034"/>
                <a:ext cx="6404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1973050" y="1213034"/>
                <a:ext cx="95037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1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2598843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3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3322251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5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 rot="5400000">
                <a:off x="3026191" y="670578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lergen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3" name="Straight Connector 102"/>
              <p:cNvCxnSpPr/>
              <p:nvPr/>
            </p:nvCxnSpPr>
            <p:spPr>
              <a:xfrm>
                <a:off x="2270270" y="1213034"/>
                <a:ext cx="172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TextBox 103"/>
              <p:cNvSpPr txBox="1"/>
              <p:nvPr/>
            </p:nvSpPr>
            <p:spPr>
              <a:xfrm rot="5400000">
                <a:off x="1165079" y="1072461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DM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 rot="5400000">
                <a:off x="1157385" y="1781796"/>
                <a:ext cx="369332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4" name="Straight Arrow Connector 113"/>
              <p:cNvCxnSpPr/>
              <p:nvPr/>
            </p:nvCxnSpPr>
            <p:spPr>
              <a:xfrm>
                <a:off x="1279577" y="2857099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Arrow Connector 114"/>
              <p:cNvCxnSpPr/>
              <p:nvPr/>
            </p:nvCxnSpPr>
            <p:spPr>
              <a:xfrm flipV="1">
                <a:off x="1289100" y="2393360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TextBox 115"/>
              <p:cNvSpPr txBox="1"/>
              <p:nvPr/>
            </p:nvSpPr>
            <p:spPr>
              <a:xfrm rot="16200000">
                <a:off x="509593" y="2217734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CR5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1374498" y="2843580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D1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920237" y="3559434"/>
              <a:ext cx="2886205" cy="1424355"/>
              <a:chOff x="548881" y="5608765"/>
              <a:chExt cx="2886205" cy="1424355"/>
            </a:xfrm>
          </p:grpSpPr>
          <p:pic>
            <p:nvPicPr>
              <p:cNvPr id="118" name="Picture 117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08440" y="560876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119" name="Picture 118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310655" y="560876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120" name="Picture 119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012870" y="560876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121" name="Picture 120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715086" y="560876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122" name="Picture 121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48881" y="6253584"/>
                <a:ext cx="771202" cy="771202"/>
              </a:xfrm>
              <a:prstGeom prst="rect">
                <a:avLst/>
              </a:prstGeom>
            </p:spPr>
          </p:pic>
          <p:pic>
            <p:nvPicPr>
              <p:cNvPr id="123" name="Picture 122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251215" y="6261918"/>
                <a:ext cx="771202" cy="771202"/>
              </a:xfrm>
              <a:prstGeom prst="rect">
                <a:avLst/>
              </a:prstGeom>
            </p:spPr>
          </p:pic>
          <p:pic>
            <p:nvPicPr>
              <p:cNvPr id="124" name="Picture 123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1957761" y="6261918"/>
                <a:ext cx="771202" cy="771202"/>
              </a:xfrm>
              <a:prstGeom prst="rect">
                <a:avLst/>
              </a:prstGeom>
            </p:spPr>
          </p:pic>
          <p:pic>
            <p:nvPicPr>
              <p:cNvPr id="125" name="Picture 124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2650655" y="6261918"/>
                <a:ext cx="771202" cy="771202"/>
              </a:xfrm>
              <a:prstGeom prst="rect">
                <a:avLst/>
              </a:prstGeom>
            </p:spPr>
          </p:pic>
        </p:grpSp>
      </p:grpSp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4707462"/>
              </p:ext>
            </p:extLst>
          </p:nvPr>
        </p:nvGraphicFramePr>
        <p:xfrm>
          <a:off x="3662847" y="3257809"/>
          <a:ext cx="1835150" cy="210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477" name="Prism 6" r:id="rId16" imgW="1834560" imgH="2108880" progId="Prism6.Document">
                  <p:embed/>
                </p:oleObj>
              </mc:Choice>
              <mc:Fallback>
                <p:oleObj name="Prism 6" r:id="rId16" imgW="1834560" imgH="21088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662847" y="3257809"/>
                        <a:ext cx="1835150" cy="210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240138"/>
              </p:ext>
            </p:extLst>
          </p:nvPr>
        </p:nvGraphicFramePr>
        <p:xfrm>
          <a:off x="5008010" y="3264159"/>
          <a:ext cx="1795463" cy="210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478" name="Prism 6" r:id="rId18" imgW="1794960" imgH="2101320" progId="Prism6.Document">
                  <p:embed/>
                </p:oleObj>
              </mc:Choice>
              <mc:Fallback>
                <p:oleObj name="Prism 6" r:id="rId18" imgW="1794960" imgH="21013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008010" y="3264159"/>
                        <a:ext cx="1795463" cy="2101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584506" y="603205"/>
            <a:ext cx="3188560" cy="2234924"/>
            <a:chOff x="584506" y="603205"/>
            <a:chExt cx="3188560" cy="2234924"/>
          </a:xfrm>
        </p:grpSpPr>
        <p:sp>
          <p:nvSpPr>
            <p:cNvPr id="57" name="TextBox 56"/>
            <p:cNvSpPr txBox="1"/>
            <p:nvPr/>
          </p:nvSpPr>
          <p:spPr>
            <a:xfrm rot="5400000">
              <a:off x="1180051" y="447271"/>
              <a:ext cx="353943" cy="66581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r>
                <a:rPr lang="en-GB" sz="1100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leen</a:t>
              </a:r>
              <a:endParaRPr lang="en-GB" sz="1100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075922" y="945973"/>
              <a:ext cx="6404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644480" y="945973"/>
              <a:ext cx="9503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ek 1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270273" y="945973"/>
              <a:ext cx="9623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ek 3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 rot="5400000">
              <a:off x="2697621" y="403517"/>
              <a:ext cx="353943" cy="8579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ergen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Straight Connector 48"/>
            <p:cNvCxnSpPr/>
            <p:nvPr/>
          </p:nvCxnSpPr>
          <p:spPr>
            <a:xfrm>
              <a:off x="1941700" y="945973"/>
              <a:ext cx="17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 rot="5400000">
              <a:off x="836509" y="805400"/>
              <a:ext cx="353943" cy="8579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DM</a:t>
              </a:r>
              <a:endParaRPr lang="en-GB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5400000">
              <a:off x="828815" y="1514735"/>
              <a:ext cx="369332" cy="8579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r>
                <a:rPr lang="en-GB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T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977449" y="1155536"/>
              <a:ext cx="720000" cy="7200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670216" y="1155536"/>
              <a:ext cx="720000" cy="7200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364971" y="1155536"/>
              <a:ext cx="720000" cy="7200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053066" y="1155536"/>
              <a:ext cx="720000" cy="720000"/>
            </a:xfrm>
            <a:prstGeom prst="rect">
              <a:avLst/>
            </a:prstGeom>
          </p:spPr>
        </p:pic>
        <p:cxnSp>
          <p:nvCxnSpPr>
            <p:cNvPr id="91" name="Straight Arrow Connector 90"/>
            <p:cNvCxnSpPr/>
            <p:nvPr/>
          </p:nvCxnSpPr>
          <p:spPr>
            <a:xfrm>
              <a:off x="951007" y="2590038"/>
              <a:ext cx="468001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91"/>
            <p:cNvCxnSpPr/>
            <p:nvPr/>
          </p:nvCxnSpPr>
          <p:spPr>
            <a:xfrm flipV="1">
              <a:off x="960530" y="2126299"/>
              <a:ext cx="767" cy="4680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 rot="16200000">
              <a:off x="181023" y="1950673"/>
              <a:ext cx="12741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CR5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045928" y="2576519"/>
              <a:ext cx="91579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1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930620" y="1790288"/>
              <a:ext cx="766829" cy="76682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623416" y="1790288"/>
              <a:ext cx="766800" cy="7668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318171" y="1790288"/>
              <a:ext cx="766800" cy="7668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3006266" y="1790288"/>
              <a:ext cx="766800" cy="766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5821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4"/>
          <p:cNvSpPr txBox="1"/>
          <p:nvPr/>
        </p:nvSpPr>
        <p:spPr>
          <a:xfrm>
            <a:off x="532818" y="3991899"/>
            <a:ext cx="577588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defRPr/>
            </a:pP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igure S3: Germinal centre B cell gating strategy 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Germinal centre B cells were identified by flow cytometry and defined as CD19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B220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gD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gM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D38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GL7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FAS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lymphocytes. </a:t>
            </a:r>
            <a:endParaRPr lang="en-GB" sz="1000" i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grpSp>
        <p:nvGrpSpPr>
          <p:cNvPr id="176" name="Group 175"/>
          <p:cNvGrpSpPr/>
          <p:nvPr/>
        </p:nvGrpSpPr>
        <p:grpSpPr>
          <a:xfrm>
            <a:off x="532819" y="547132"/>
            <a:ext cx="5380616" cy="3116711"/>
            <a:chOff x="532819" y="547132"/>
            <a:chExt cx="5380616" cy="3116711"/>
          </a:xfrm>
        </p:grpSpPr>
        <p:grpSp>
          <p:nvGrpSpPr>
            <p:cNvPr id="174" name="Group 173"/>
            <p:cNvGrpSpPr/>
            <p:nvPr/>
          </p:nvGrpSpPr>
          <p:grpSpPr>
            <a:xfrm>
              <a:off x="970906" y="547132"/>
              <a:ext cx="1247256" cy="1393744"/>
              <a:chOff x="970906" y="547132"/>
              <a:chExt cx="1247256" cy="1393744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46834" y="735374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73" name="Group 72"/>
              <p:cNvGrpSpPr/>
              <p:nvPr/>
            </p:nvGrpSpPr>
            <p:grpSpPr>
              <a:xfrm>
                <a:off x="970906" y="547132"/>
                <a:ext cx="1247256" cy="1393744"/>
                <a:chOff x="621285" y="475518"/>
                <a:chExt cx="1247256" cy="1393744"/>
              </a:xfrm>
            </p:grpSpPr>
            <p:cxnSp>
              <p:nvCxnSpPr>
                <p:cNvPr id="110" name="Straight Arrow Connector 109"/>
                <p:cNvCxnSpPr/>
                <p:nvPr/>
              </p:nvCxnSpPr>
              <p:spPr>
                <a:xfrm>
                  <a:off x="857822" y="1621171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Straight Arrow Connector 110"/>
                <p:cNvCxnSpPr/>
                <p:nvPr/>
              </p:nvCxnSpPr>
              <p:spPr>
                <a:xfrm flipV="1">
                  <a:off x="867345" y="1157432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2" name="TextBox 111"/>
                <p:cNvSpPr txBox="1"/>
                <p:nvPr/>
              </p:nvSpPr>
              <p:spPr>
                <a:xfrm rot="16200000">
                  <a:off x="114997" y="981806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V Live dead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952743" y="1607652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73" name="Group 172"/>
            <p:cNvGrpSpPr/>
            <p:nvPr/>
          </p:nvGrpSpPr>
          <p:grpSpPr>
            <a:xfrm>
              <a:off x="2188005" y="547132"/>
              <a:ext cx="1238203" cy="1393744"/>
              <a:chOff x="2188005" y="547132"/>
              <a:chExt cx="1238203" cy="1393744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43283" y="735374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74" name="Group 73"/>
              <p:cNvGrpSpPr/>
              <p:nvPr/>
            </p:nvGrpSpPr>
            <p:grpSpPr>
              <a:xfrm>
                <a:off x="2188005" y="547132"/>
                <a:ext cx="1238203" cy="1393744"/>
                <a:chOff x="2110446" y="473253"/>
                <a:chExt cx="1238203" cy="1393744"/>
              </a:xfrm>
            </p:grpSpPr>
            <p:cxnSp>
              <p:nvCxnSpPr>
                <p:cNvPr id="114" name="Straight Arrow Connector 113"/>
                <p:cNvCxnSpPr/>
                <p:nvPr/>
              </p:nvCxnSpPr>
              <p:spPr>
                <a:xfrm>
                  <a:off x="2337930" y="1618906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Straight Arrow Connector 114"/>
                <p:cNvCxnSpPr/>
                <p:nvPr/>
              </p:nvCxnSpPr>
              <p:spPr>
                <a:xfrm flipV="1">
                  <a:off x="2347453" y="1155167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" name="TextBox 115"/>
                <p:cNvSpPr txBox="1"/>
                <p:nvPr/>
              </p:nvSpPr>
              <p:spPr>
                <a:xfrm rot="16200000">
                  <a:off x="1604158" y="979541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W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2432851" y="1605387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118" name="Straight Arrow Connector 117"/>
            <p:cNvCxnSpPr/>
            <p:nvPr/>
          </p:nvCxnSpPr>
          <p:spPr>
            <a:xfrm flipV="1">
              <a:off x="2066121" y="1099516"/>
              <a:ext cx="620370" cy="14225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2" name="Group 171"/>
            <p:cNvGrpSpPr/>
            <p:nvPr/>
          </p:nvGrpSpPr>
          <p:grpSpPr>
            <a:xfrm>
              <a:off x="3377112" y="547132"/>
              <a:ext cx="1238203" cy="1393744"/>
              <a:chOff x="3377112" y="547132"/>
              <a:chExt cx="1238203" cy="1393744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639732" y="735374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89" name="Group 88"/>
              <p:cNvGrpSpPr/>
              <p:nvPr/>
            </p:nvGrpSpPr>
            <p:grpSpPr>
              <a:xfrm>
                <a:off x="3377112" y="547132"/>
                <a:ext cx="1238203" cy="1393744"/>
                <a:chOff x="3228897" y="618713"/>
                <a:chExt cx="1238203" cy="1393744"/>
              </a:xfrm>
            </p:grpSpPr>
            <p:cxnSp>
              <p:nvCxnSpPr>
                <p:cNvPr id="120" name="Straight Arrow Connector 119"/>
                <p:cNvCxnSpPr/>
                <p:nvPr/>
              </p:nvCxnSpPr>
              <p:spPr>
                <a:xfrm>
                  <a:off x="3456381" y="1764366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Arrow Connector 120"/>
                <p:cNvCxnSpPr/>
                <p:nvPr/>
              </p:nvCxnSpPr>
              <p:spPr>
                <a:xfrm flipV="1">
                  <a:off x="3465904" y="1300627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TextBox 121"/>
                <p:cNvSpPr txBox="1"/>
                <p:nvPr/>
              </p:nvSpPr>
              <p:spPr>
                <a:xfrm rot="16200000">
                  <a:off x="2722609" y="1125001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W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3551302" y="1750847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124" name="Straight Arrow Connector 123"/>
            <p:cNvCxnSpPr/>
            <p:nvPr/>
          </p:nvCxnSpPr>
          <p:spPr>
            <a:xfrm flipV="1">
              <a:off x="3098038" y="1160793"/>
              <a:ext cx="620370" cy="14225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1" name="Group 170"/>
            <p:cNvGrpSpPr/>
            <p:nvPr/>
          </p:nvGrpSpPr>
          <p:grpSpPr>
            <a:xfrm>
              <a:off x="4552473" y="547132"/>
              <a:ext cx="1238203" cy="1393744"/>
              <a:chOff x="4552473" y="547132"/>
              <a:chExt cx="1238203" cy="1393744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836182" y="735374"/>
                <a:ext cx="900000" cy="900000"/>
              </a:xfrm>
              <a:prstGeom prst="rect">
                <a:avLst/>
              </a:prstGeom>
            </p:spPr>
          </p:pic>
          <p:grpSp>
            <p:nvGrpSpPr>
              <p:cNvPr id="131" name="Group 130"/>
              <p:cNvGrpSpPr/>
              <p:nvPr/>
            </p:nvGrpSpPr>
            <p:grpSpPr>
              <a:xfrm>
                <a:off x="4552473" y="547132"/>
                <a:ext cx="1238203" cy="1393744"/>
                <a:chOff x="4432964" y="589943"/>
                <a:chExt cx="1238203" cy="1393744"/>
              </a:xfrm>
            </p:grpSpPr>
            <p:cxnSp>
              <p:nvCxnSpPr>
                <p:cNvPr id="125" name="Straight Arrow Connector 124"/>
                <p:cNvCxnSpPr/>
                <p:nvPr/>
              </p:nvCxnSpPr>
              <p:spPr>
                <a:xfrm>
                  <a:off x="4660448" y="1735596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Arrow Connector 125"/>
                <p:cNvCxnSpPr/>
                <p:nvPr/>
              </p:nvCxnSpPr>
              <p:spPr>
                <a:xfrm flipV="1">
                  <a:off x="4669971" y="1271857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7" name="TextBox 126"/>
                <p:cNvSpPr txBox="1"/>
                <p:nvPr/>
              </p:nvSpPr>
              <p:spPr>
                <a:xfrm rot="16200000">
                  <a:off x="3926676" y="1096231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4755369" y="1722077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129" name="Straight Arrow Connector 128"/>
            <p:cNvCxnSpPr/>
            <p:nvPr/>
          </p:nvCxnSpPr>
          <p:spPr>
            <a:xfrm flipV="1">
              <a:off x="4362025" y="1187363"/>
              <a:ext cx="620370" cy="14225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0" name="Group 169"/>
            <p:cNvGrpSpPr/>
            <p:nvPr/>
          </p:nvGrpSpPr>
          <p:grpSpPr>
            <a:xfrm>
              <a:off x="532819" y="2270099"/>
              <a:ext cx="1238203" cy="1393744"/>
              <a:chOff x="532819" y="2270099"/>
              <a:chExt cx="1238203" cy="1393744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92118" y="2555087"/>
                <a:ext cx="810000" cy="810000"/>
              </a:xfrm>
              <a:prstGeom prst="rect">
                <a:avLst/>
              </a:prstGeom>
            </p:spPr>
          </p:pic>
          <p:grpSp>
            <p:nvGrpSpPr>
              <p:cNvPr id="136" name="Group 135"/>
              <p:cNvGrpSpPr/>
              <p:nvPr/>
            </p:nvGrpSpPr>
            <p:grpSpPr>
              <a:xfrm>
                <a:off x="532819" y="2270099"/>
                <a:ext cx="1238203" cy="1393744"/>
                <a:chOff x="613542" y="2360157"/>
                <a:chExt cx="1238203" cy="1393744"/>
              </a:xfrm>
            </p:grpSpPr>
            <p:cxnSp>
              <p:nvCxnSpPr>
                <p:cNvPr id="132" name="Straight Arrow Connector 131"/>
                <p:cNvCxnSpPr/>
                <p:nvPr/>
              </p:nvCxnSpPr>
              <p:spPr>
                <a:xfrm>
                  <a:off x="841026" y="3505810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Straight Arrow Connector 132"/>
                <p:cNvCxnSpPr/>
                <p:nvPr/>
              </p:nvCxnSpPr>
              <p:spPr>
                <a:xfrm flipV="1">
                  <a:off x="850549" y="3042071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TextBox 133"/>
                <p:cNvSpPr txBox="1"/>
                <p:nvPr/>
              </p:nvSpPr>
              <p:spPr>
                <a:xfrm rot="16200000">
                  <a:off x="107254" y="2866445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9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>
                  <a:off x="935947" y="3492291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69" name="Group 168"/>
            <p:cNvGrpSpPr/>
            <p:nvPr/>
          </p:nvGrpSpPr>
          <p:grpSpPr>
            <a:xfrm>
              <a:off x="1574650" y="2270099"/>
              <a:ext cx="1238203" cy="1393744"/>
              <a:chOff x="1574650" y="2270099"/>
              <a:chExt cx="1238203" cy="1393744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826033" y="2555087"/>
                <a:ext cx="810000" cy="810000"/>
              </a:xfrm>
              <a:prstGeom prst="rect">
                <a:avLst/>
              </a:prstGeom>
            </p:spPr>
          </p:pic>
          <p:grpSp>
            <p:nvGrpSpPr>
              <p:cNvPr id="137" name="Group 136"/>
              <p:cNvGrpSpPr/>
              <p:nvPr/>
            </p:nvGrpSpPr>
            <p:grpSpPr>
              <a:xfrm>
                <a:off x="1574650" y="2270099"/>
                <a:ext cx="1238203" cy="1393744"/>
                <a:chOff x="613542" y="2360157"/>
                <a:chExt cx="1238203" cy="1393744"/>
              </a:xfrm>
            </p:grpSpPr>
            <p:cxnSp>
              <p:nvCxnSpPr>
                <p:cNvPr id="138" name="Straight Arrow Connector 137"/>
                <p:cNvCxnSpPr/>
                <p:nvPr/>
              </p:nvCxnSpPr>
              <p:spPr>
                <a:xfrm>
                  <a:off x="841026" y="3505810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Straight Arrow Connector 138"/>
                <p:cNvCxnSpPr/>
                <p:nvPr/>
              </p:nvCxnSpPr>
              <p:spPr>
                <a:xfrm flipV="1">
                  <a:off x="850549" y="3042071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TextBox 139"/>
                <p:cNvSpPr txBox="1"/>
                <p:nvPr/>
              </p:nvSpPr>
              <p:spPr>
                <a:xfrm rot="16200000">
                  <a:off x="107254" y="2866445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9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935947" y="3492291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220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68" name="Group 167"/>
            <p:cNvGrpSpPr/>
            <p:nvPr/>
          </p:nvGrpSpPr>
          <p:grpSpPr>
            <a:xfrm>
              <a:off x="2593306" y="2270099"/>
              <a:ext cx="1247256" cy="1393744"/>
              <a:chOff x="2593306" y="2270099"/>
              <a:chExt cx="1247256" cy="1393744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859948" y="2555087"/>
                <a:ext cx="810000" cy="810000"/>
              </a:xfrm>
              <a:prstGeom prst="rect">
                <a:avLst/>
              </a:prstGeom>
            </p:spPr>
          </p:pic>
          <p:grpSp>
            <p:nvGrpSpPr>
              <p:cNvPr id="142" name="Group 141"/>
              <p:cNvGrpSpPr/>
              <p:nvPr/>
            </p:nvGrpSpPr>
            <p:grpSpPr>
              <a:xfrm>
                <a:off x="2593306" y="2270099"/>
                <a:ext cx="1247256" cy="1393744"/>
                <a:chOff x="604489" y="2360157"/>
                <a:chExt cx="1247256" cy="1393744"/>
              </a:xfrm>
            </p:grpSpPr>
            <p:cxnSp>
              <p:nvCxnSpPr>
                <p:cNvPr id="143" name="Straight Arrow Connector 142"/>
                <p:cNvCxnSpPr/>
                <p:nvPr/>
              </p:nvCxnSpPr>
              <p:spPr>
                <a:xfrm>
                  <a:off x="841026" y="3505810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Arrow Connector 143"/>
                <p:cNvCxnSpPr/>
                <p:nvPr/>
              </p:nvCxnSpPr>
              <p:spPr>
                <a:xfrm flipV="1">
                  <a:off x="850549" y="3042071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5" name="TextBox 144"/>
                <p:cNvSpPr txBox="1"/>
                <p:nvPr/>
              </p:nvSpPr>
              <p:spPr>
                <a:xfrm rot="16200000">
                  <a:off x="98201" y="2866445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gD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935947" y="3492291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gM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67" name="Group 166"/>
            <p:cNvGrpSpPr/>
            <p:nvPr/>
          </p:nvGrpSpPr>
          <p:grpSpPr>
            <a:xfrm>
              <a:off x="3642647" y="2270099"/>
              <a:ext cx="1238203" cy="1393744"/>
              <a:chOff x="3642647" y="2270099"/>
              <a:chExt cx="1238203" cy="1393744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893863" y="2555087"/>
                <a:ext cx="810000" cy="810000"/>
              </a:xfrm>
              <a:prstGeom prst="rect">
                <a:avLst/>
              </a:prstGeom>
            </p:spPr>
          </p:pic>
          <p:grpSp>
            <p:nvGrpSpPr>
              <p:cNvPr id="147" name="Group 146"/>
              <p:cNvGrpSpPr/>
              <p:nvPr/>
            </p:nvGrpSpPr>
            <p:grpSpPr>
              <a:xfrm>
                <a:off x="3642647" y="2270099"/>
                <a:ext cx="1238203" cy="1393744"/>
                <a:chOff x="613542" y="2360157"/>
                <a:chExt cx="1238203" cy="1393744"/>
              </a:xfrm>
            </p:grpSpPr>
            <p:cxnSp>
              <p:nvCxnSpPr>
                <p:cNvPr id="148" name="Straight Arrow Connector 147"/>
                <p:cNvCxnSpPr/>
                <p:nvPr/>
              </p:nvCxnSpPr>
              <p:spPr>
                <a:xfrm>
                  <a:off x="841026" y="3505810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Straight Arrow Connector 148"/>
                <p:cNvCxnSpPr/>
                <p:nvPr/>
              </p:nvCxnSpPr>
              <p:spPr>
                <a:xfrm flipV="1">
                  <a:off x="850549" y="3042071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TextBox 149"/>
                <p:cNvSpPr txBox="1"/>
                <p:nvPr/>
              </p:nvSpPr>
              <p:spPr>
                <a:xfrm rot="16200000">
                  <a:off x="107254" y="2866445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8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935947" y="3492291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7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152" name="Straight Arrow Connector 151"/>
            <p:cNvCxnSpPr/>
            <p:nvPr/>
          </p:nvCxnSpPr>
          <p:spPr>
            <a:xfrm flipV="1">
              <a:off x="1164269" y="2713674"/>
              <a:ext cx="720000" cy="336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Arrow Connector 158"/>
            <p:cNvCxnSpPr/>
            <p:nvPr/>
          </p:nvCxnSpPr>
          <p:spPr>
            <a:xfrm flipV="1">
              <a:off x="2523490" y="2730591"/>
              <a:ext cx="396000" cy="336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Arrow Connector 159"/>
            <p:cNvCxnSpPr/>
            <p:nvPr/>
          </p:nvCxnSpPr>
          <p:spPr>
            <a:xfrm flipV="1">
              <a:off x="3113578" y="2807459"/>
              <a:ext cx="851474" cy="3077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Arrow Connector 161"/>
            <p:cNvCxnSpPr/>
            <p:nvPr/>
          </p:nvCxnSpPr>
          <p:spPr>
            <a:xfrm flipV="1">
              <a:off x="4433325" y="2787621"/>
              <a:ext cx="549070" cy="2865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6" name="Group 165"/>
            <p:cNvGrpSpPr/>
            <p:nvPr/>
          </p:nvGrpSpPr>
          <p:grpSpPr>
            <a:xfrm>
              <a:off x="4675232" y="2270099"/>
              <a:ext cx="1238203" cy="1393744"/>
              <a:chOff x="4675232" y="2270099"/>
              <a:chExt cx="1238203" cy="1393744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927777" y="2555087"/>
                <a:ext cx="810000" cy="810000"/>
              </a:xfrm>
              <a:prstGeom prst="rect">
                <a:avLst/>
              </a:prstGeom>
            </p:spPr>
          </p:pic>
          <p:grpSp>
            <p:nvGrpSpPr>
              <p:cNvPr id="154" name="Group 153"/>
              <p:cNvGrpSpPr/>
              <p:nvPr/>
            </p:nvGrpSpPr>
            <p:grpSpPr>
              <a:xfrm>
                <a:off x="4675232" y="2270099"/>
                <a:ext cx="1238203" cy="1393744"/>
                <a:chOff x="613542" y="2360157"/>
                <a:chExt cx="1238203" cy="1393744"/>
              </a:xfrm>
            </p:grpSpPr>
            <p:cxnSp>
              <p:nvCxnSpPr>
                <p:cNvPr id="155" name="Straight Arrow Connector 154"/>
                <p:cNvCxnSpPr/>
                <p:nvPr/>
              </p:nvCxnSpPr>
              <p:spPr>
                <a:xfrm>
                  <a:off x="841026" y="3505810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Straight Arrow Connector 155"/>
                <p:cNvCxnSpPr/>
                <p:nvPr/>
              </p:nvCxnSpPr>
              <p:spPr>
                <a:xfrm flipV="1">
                  <a:off x="850549" y="3042071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TextBox 156"/>
                <p:cNvSpPr txBox="1"/>
                <p:nvPr/>
              </p:nvSpPr>
              <p:spPr>
                <a:xfrm rot="16200000">
                  <a:off x="107254" y="2866445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7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TextBox 157"/>
                <p:cNvSpPr txBox="1"/>
                <p:nvPr/>
              </p:nvSpPr>
              <p:spPr>
                <a:xfrm>
                  <a:off x="935947" y="3492291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AS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65" name="Rectangle 164"/>
              <p:cNvSpPr/>
              <p:nvPr/>
            </p:nvSpPr>
            <p:spPr>
              <a:xfrm>
                <a:off x="5097102" y="2634558"/>
                <a:ext cx="371192" cy="53415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994286" y="1510816"/>
              <a:ext cx="4419656" cy="1103593"/>
              <a:chOff x="1606867" y="1654198"/>
              <a:chExt cx="4419656" cy="1103593"/>
            </a:xfrm>
          </p:grpSpPr>
          <p:cxnSp>
            <p:nvCxnSpPr>
              <p:cNvPr id="108" name="Straight Connector 107"/>
              <p:cNvCxnSpPr/>
              <p:nvPr/>
            </p:nvCxnSpPr>
            <p:spPr>
              <a:xfrm flipH="1">
                <a:off x="1606867" y="2415711"/>
                <a:ext cx="441965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Arrow Connector 108"/>
              <p:cNvCxnSpPr/>
              <p:nvPr/>
            </p:nvCxnSpPr>
            <p:spPr>
              <a:xfrm>
                <a:off x="1606867" y="2410847"/>
                <a:ext cx="0" cy="346944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6026523" y="1654198"/>
                <a:ext cx="0" cy="771241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19240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1" name="Group 150"/>
          <p:cNvGrpSpPr/>
          <p:nvPr/>
        </p:nvGrpSpPr>
        <p:grpSpPr>
          <a:xfrm>
            <a:off x="959832" y="603205"/>
            <a:ext cx="3371527" cy="2234924"/>
            <a:chOff x="584506" y="603205"/>
            <a:chExt cx="3371527" cy="2234924"/>
          </a:xfrm>
        </p:grpSpPr>
        <p:sp>
          <p:nvSpPr>
            <p:cNvPr id="4" name="TextBox 3"/>
            <p:cNvSpPr txBox="1"/>
            <p:nvPr/>
          </p:nvSpPr>
          <p:spPr>
            <a:xfrm rot="5400000">
              <a:off x="1180051" y="447271"/>
              <a:ext cx="353943" cy="66581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  <a:scene3d>
                <a:camera prst="orthographicFront">
                  <a:rot lat="0" lon="0" rev="0"/>
                </a:camera>
                <a:lightRig rig="threePt" dir="t"/>
              </a:scene3d>
            </a:bodyPr>
            <a:lstStyle/>
            <a:p>
              <a:r>
                <a:rPr lang="en-GB" sz="1100" b="1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LN</a:t>
              </a:r>
              <a:endParaRPr lang="en-GB" sz="1100" b="1" u="sng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584506" y="655520"/>
              <a:ext cx="3371527" cy="2182609"/>
              <a:chOff x="913076" y="922581"/>
              <a:chExt cx="3371527" cy="2182609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404492" y="1213034"/>
                <a:ext cx="6404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973050" y="1213034"/>
                <a:ext cx="95037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1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598843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3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22251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5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5400000">
                <a:off x="3026191" y="670578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lergen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Connector 11"/>
              <p:cNvCxnSpPr/>
              <p:nvPr/>
            </p:nvCxnSpPr>
            <p:spPr>
              <a:xfrm>
                <a:off x="2270270" y="1213034"/>
                <a:ext cx="172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 rot="5400000">
                <a:off x="1165079" y="1072461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DM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5400000">
                <a:off x="1157385" y="1781796"/>
                <a:ext cx="369332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Straight Arrow Connector 22"/>
              <p:cNvCxnSpPr/>
              <p:nvPr/>
            </p:nvCxnSpPr>
            <p:spPr>
              <a:xfrm>
                <a:off x="1279577" y="2857099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/>
              <p:cNvCxnSpPr/>
              <p:nvPr/>
            </p:nvCxnSpPr>
            <p:spPr>
              <a:xfrm flipV="1">
                <a:off x="1289100" y="2393360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 rot="16200000">
                <a:off x="509593" y="2217734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8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374498" y="2843580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7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84368" y="1135345"/>
              <a:ext cx="720000" cy="720000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63458" y="1135345"/>
              <a:ext cx="720000" cy="720000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54417" y="1135345"/>
              <a:ext cx="720000" cy="720000"/>
            </a:xfrm>
            <a:prstGeom prst="rect">
              <a:avLst/>
            </a:prstGeom>
          </p:spPr>
        </p:pic>
        <p:pic>
          <p:nvPicPr>
            <p:cNvPr id="55" name="Picture 5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75327" y="1135345"/>
              <a:ext cx="720000" cy="720000"/>
            </a:xfrm>
            <a:prstGeom prst="rect">
              <a:avLst/>
            </a:prstGeom>
          </p:spPr>
        </p:pic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84368" y="1823941"/>
              <a:ext cx="720000" cy="720000"/>
            </a:xfrm>
            <a:prstGeom prst="rect">
              <a:avLst/>
            </a:prstGeom>
          </p:spPr>
        </p:pic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75327" y="1823941"/>
              <a:ext cx="720000" cy="720000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63458" y="1823941"/>
              <a:ext cx="720000" cy="720000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054417" y="1823941"/>
              <a:ext cx="720000" cy="720000"/>
            </a:xfrm>
            <a:prstGeom prst="rect">
              <a:avLst/>
            </a:prstGeom>
          </p:spPr>
        </p:pic>
      </p:grpSp>
      <p:sp>
        <p:nvSpPr>
          <p:cNvPr id="27" name="TextBox 26"/>
          <p:cNvSpPr txBox="1"/>
          <p:nvPr/>
        </p:nvSpPr>
        <p:spPr>
          <a:xfrm rot="5400000">
            <a:off x="1551412" y="2864641"/>
            <a:ext cx="353943" cy="665812"/>
          </a:xfrm>
          <a:prstGeom prst="rect">
            <a:avLst/>
          </a:prstGeom>
          <a:noFill/>
        </p:spPr>
        <p:txBody>
          <a:bodyPr vert="vert270" wrap="square" rtlCol="0">
            <a:spAutoFit/>
            <a:scene3d>
              <a:camera prst="orthographicFront">
                <a:rot lat="0" lon="0" rev="0"/>
              </a:camera>
              <a:lightRig rig="threePt" dir="t"/>
            </a:scene3d>
          </a:bodyPr>
          <a:lstStyle/>
          <a:p>
            <a:r>
              <a:rPr lang="en-GB" sz="11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endParaRPr lang="en-GB" sz="11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955867" y="3072890"/>
            <a:ext cx="3371527" cy="2182609"/>
            <a:chOff x="955867" y="3072890"/>
            <a:chExt cx="3371527" cy="2182609"/>
          </a:xfrm>
        </p:grpSpPr>
        <p:grpSp>
          <p:nvGrpSpPr>
            <p:cNvPr id="30" name="Group 29"/>
            <p:cNvGrpSpPr/>
            <p:nvPr/>
          </p:nvGrpSpPr>
          <p:grpSpPr>
            <a:xfrm>
              <a:off x="955867" y="3072890"/>
              <a:ext cx="3371527" cy="2182609"/>
              <a:chOff x="913076" y="922581"/>
              <a:chExt cx="3371527" cy="2182609"/>
            </a:xfrm>
          </p:grpSpPr>
          <p:sp>
            <p:nvSpPr>
              <p:cNvPr id="50" name="TextBox 49"/>
              <p:cNvSpPr txBox="1"/>
              <p:nvPr/>
            </p:nvSpPr>
            <p:spPr>
              <a:xfrm rot="16200000">
                <a:off x="509593" y="2217734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8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404492" y="1213034"/>
                <a:ext cx="6404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973050" y="1213034"/>
                <a:ext cx="95037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1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598843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3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322251" y="1213034"/>
                <a:ext cx="9623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 5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5400000">
                <a:off x="3026191" y="670578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lergen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5" name="Straight Connector 44"/>
              <p:cNvCxnSpPr/>
              <p:nvPr/>
            </p:nvCxnSpPr>
            <p:spPr>
              <a:xfrm>
                <a:off x="2270270" y="1213034"/>
                <a:ext cx="172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 rot="5400000">
                <a:off x="1165079" y="1072461"/>
                <a:ext cx="353943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DM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5400000">
                <a:off x="1157385" y="1781796"/>
                <a:ext cx="369332" cy="8579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8" name="Straight Arrow Connector 47"/>
              <p:cNvCxnSpPr/>
              <p:nvPr/>
            </p:nvCxnSpPr>
            <p:spPr>
              <a:xfrm>
                <a:off x="1279577" y="2857099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flipV="1">
                <a:off x="1289100" y="2393360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1374498" y="2843580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7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343573" y="3529525"/>
              <a:ext cx="2822132" cy="1423630"/>
              <a:chOff x="1343573" y="3529525"/>
              <a:chExt cx="2822132" cy="1423630"/>
            </a:xfrm>
          </p:grpSpPr>
          <p:pic>
            <p:nvPicPr>
              <p:cNvPr id="60" name="Picture 59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343573" y="352952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1" name="Picture 60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036909" y="352952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2" name="Picture 61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737619" y="352952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445705" y="352952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4" name="Picture 63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343573" y="423315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5" name="Picture 64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2036909" y="423315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6" name="Picture 65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2737619" y="4233155"/>
                <a:ext cx="720000" cy="720000"/>
              </a:xfrm>
              <a:prstGeom prst="rect">
                <a:avLst/>
              </a:prstGeom>
            </p:spPr>
          </p:pic>
          <p:pic>
            <p:nvPicPr>
              <p:cNvPr id="67" name="Picture 66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445705" y="4233155"/>
                <a:ext cx="720000" cy="720000"/>
              </a:xfrm>
              <a:prstGeom prst="rect">
                <a:avLst/>
              </a:prstGeom>
            </p:spPr>
          </p:pic>
        </p:grpSp>
      </p:grpSp>
      <p:sp>
        <p:nvSpPr>
          <p:cNvPr id="154" name="TextBox 153"/>
          <p:cNvSpPr txBox="1"/>
          <p:nvPr/>
        </p:nvSpPr>
        <p:spPr>
          <a:xfrm>
            <a:off x="589560" y="7814698"/>
            <a:ext cx="552614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igure S4: GC B cells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accumulate over tim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following allergen exposure. </a:t>
            </a:r>
          </a:p>
          <a:p>
            <a:pPr algn="just"/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dult female BALB/c mice were exposed to either 25 µg house dust mite (HDM), 10 µg </a:t>
            </a:r>
            <a:r>
              <a:rPr lang="en-GB" sz="1000" i="1" dirty="0" err="1">
                <a:latin typeface="Arial" charset="0"/>
                <a:ea typeface="Arial" charset="0"/>
                <a:cs typeface="Arial" charset="0"/>
              </a:rPr>
              <a:t>alternaria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alternata 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LT) or 25 µl phosphate buffered saline (PB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 for up to 5 weeks. Flow cytometry was used to determine the frequency of germinal centre (GC) B cells within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cellular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ompartments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following allergen exposure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GC B cell were defined as CD38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GL7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AS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B220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000" baseline="30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ell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Representative flow plots of GC B cells in PBS, ALT or HDM treated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nimals, pre-gated on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D19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B220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lymphocyte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Mediastinal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lymph node 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mLN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Lung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pleen. Representative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data from 2 independent experiments. 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509028" y="62986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509028" y="299448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09028" y="5402482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926414" y="5414817"/>
            <a:ext cx="3371527" cy="2234924"/>
            <a:chOff x="926414" y="5414817"/>
            <a:chExt cx="3371527" cy="2234924"/>
          </a:xfrm>
        </p:grpSpPr>
        <p:grpSp>
          <p:nvGrpSpPr>
            <p:cNvPr id="70" name="Group 69"/>
            <p:cNvGrpSpPr/>
            <p:nvPr/>
          </p:nvGrpSpPr>
          <p:grpSpPr>
            <a:xfrm>
              <a:off x="926414" y="5414817"/>
              <a:ext cx="3371527" cy="2234924"/>
              <a:chOff x="580541" y="3020575"/>
              <a:chExt cx="3371527" cy="2234924"/>
            </a:xfrm>
          </p:grpSpPr>
          <p:sp>
            <p:nvSpPr>
              <p:cNvPr id="71" name="TextBox 70"/>
              <p:cNvSpPr txBox="1"/>
              <p:nvPr/>
            </p:nvSpPr>
            <p:spPr>
              <a:xfrm rot="5400000">
                <a:off x="1176086" y="2864641"/>
                <a:ext cx="353943" cy="66581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100" b="1" u="sng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leen</a:t>
                </a:r>
                <a:endParaRPr lang="en-GB" sz="1100" b="1" u="sng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2" name="Group 71"/>
              <p:cNvGrpSpPr/>
              <p:nvPr/>
            </p:nvGrpSpPr>
            <p:grpSpPr>
              <a:xfrm>
                <a:off x="580541" y="3072890"/>
                <a:ext cx="3371527" cy="2182609"/>
                <a:chOff x="913076" y="922581"/>
                <a:chExt cx="3371527" cy="2182609"/>
              </a:xfrm>
            </p:grpSpPr>
            <p:sp>
              <p:nvSpPr>
                <p:cNvPr id="81" name="TextBox 80"/>
                <p:cNvSpPr txBox="1"/>
                <p:nvPr/>
              </p:nvSpPr>
              <p:spPr>
                <a:xfrm>
                  <a:off x="1404492" y="1213034"/>
                  <a:ext cx="64047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BS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1973050" y="1213034"/>
                  <a:ext cx="9503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eek 1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2598843" y="1213034"/>
                  <a:ext cx="96235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eek 3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322251" y="1213034"/>
                  <a:ext cx="96235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eek 5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 rot="5400000">
                  <a:off x="3026191" y="670578"/>
                  <a:ext cx="353943" cy="857949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  <a:scene3d>
                    <a:camera prst="orthographicFront">
                      <a:rot lat="0" lon="0" rev="0"/>
                    </a:camera>
                    <a:lightRig rig="threePt" dir="t"/>
                  </a:scene3d>
                </a:bodyPr>
                <a:lstStyle/>
                <a:p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lergen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6" name="Straight Connector 85"/>
                <p:cNvCxnSpPr/>
                <p:nvPr/>
              </p:nvCxnSpPr>
              <p:spPr>
                <a:xfrm>
                  <a:off x="2270270" y="1213034"/>
                  <a:ext cx="17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/>
                <p:cNvSpPr txBox="1"/>
                <p:nvPr/>
              </p:nvSpPr>
              <p:spPr>
                <a:xfrm rot="5400000">
                  <a:off x="1165079" y="1072461"/>
                  <a:ext cx="353943" cy="857949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  <a:scene3d>
                    <a:camera prst="orthographicFront">
                      <a:rot lat="0" lon="0" rev="0"/>
                    </a:camera>
                    <a:lightRig rig="threePt" dir="t"/>
                  </a:scene3d>
                </a:bodyPr>
                <a:lstStyle/>
                <a:p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DM</a:t>
                  </a:r>
                  <a:endPara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 rot="5400000">
                  <a:off x="1157385" y="1781796"/>
                  <a:ext cx="369332" cy="857949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  <a:scene3d>
                    <a:camera prst="orthographicFront">
                      <a:rot lat="0" lon="0" rev="0"/>
                    </a:camera>
                    <a:lightRig rig="threePt" dir="t"/>
                  </a:scene3d>
                </a:bodyPr>
                <a:lstStyle/>
                <a:p>
                  <a:r>
                    <a:rPr lang="en-GB" sz="11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T</a:t>
                  </a:r>
                  <a:endPara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89" name="Straight Arrow Connector 88"/>
                <p:cNvCxnSpPr/>
                <p:nvPr/>
              </p:nvCxnSpPr>
              <p:spPr>
                <a:xfrm>
                  <a:off x="1279577" y="2857099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Straight Arrow Connector 89"/>
                <p:cNvCxnSpPr/>
                <p:nvPr/>
              </p:nvCxnSpPr>
              <p:spPr>
                <a:xfrm flipV="1">
                  <a:off x="1289100" y="2393360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" name="TextBox 90"/>
                <p:cNvSpPr txBox="1"/>
                <p:nvPr/>
              </p:nvSpPr>
              <p:spPr>
                <a:xfrm rot="16200000">
                  <a:off x="509593" y="2217734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38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1374498" y="2843580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7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pic>
          <p:nvPicPr>
            <p:cNvPr id="140" name="Picture 139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329744" y="5930110"/>
              <a:ext cx="720000" cy="720000"/>
            </a:xfrm>
            <a:prstGeom prst="rect">
              <a:avLst/>
            </a:prstGeom>
          </p:spPr>
        </p:pic>
        <p:pic>
          <p:nvPicPr>
            <p:cNvPr id="141" name="Picture 140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022832" y="5930110"/>
              <a:ext cx="720000" cy="720000"/>
            </a:xfrm>
            <a:prstGeom prst="rect">
              <a:avLst/>
            </a:prstGeom>
          </p:spPr>
        </p:pic>
        <p:pic>
          <p:nvPicPr>
            <p:cNvPr id="142" name="Picture 141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710058" y="5930110"/>
              <a:ext cx="720000" cy="720000"/>
            </a:xfrm>
            <a:prstGeom prst="rect">
              <a:avLst/>
            </a:prstGeom>
          </p:spPr>
        </p:pic>
        <p:pic>
          <p:nvPicPr>
            <p:cNvPr id="143" name="Picture 142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3406910" y="5930110"/>
              <a:ext cx="720000" cy="72000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310369" y="6663871"/>
              <a:ext cx="720000" cy="7200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014818" y="6652220"/>
              <a:ext cx="720000" cy="720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739201" y="6625505"/>
              <a:ext cx="720000" cy="7200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3405477" y="6632296"/>
              <a:ext cx="720000" cy="7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440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2479494"/>
              </p:ext>
            </p:extLst>
          </p:nvPr>
        </p:nvGraphicFramePr>
        <p:xfrm>
          <a:off x="528638" y="738188"/>
          <a:ext cx="1825625" cy="1774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8256" name="Prism 6" r:id="rId3" imgW="2299680" imgH="2232360" progId="Prism6.Document">
                  <p:embed/>
                </p:oleObj>
              </mc:Choice>
              <mc:Fallback>
                <p:oleObj name="Prism 6" r:id="rId3" imgW="2299680" imgH="22323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8638" y="738188"/>
                        <a:ext cx="1825625" cy="1774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26932" y="592378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26932" y="2775550"/>
            <a:ext cx="583165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5: ICOS/ICOS-L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interactions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reduces serum MCPT1.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were expose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(i.n) to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25 µ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ouse dust mit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HDM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r 25 µl phosphate buffered saline (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BS), 3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times a week for 5 weeks. From the start of week 4 mice were also administered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150 µ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body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. Mice were culled at the end of week 5.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erum MCPT1 was measured by ELISA. Statistical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ignificance was determined using a Mann Whitney U test. 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p&lt;0.001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Data is from 1 study, n=4 for PBS treated groups, n=6 for HDM treated groups.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  <a:p>
            <a:pPr algn="just">
              <a:defRPr/>
            </a:pP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9847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1553085"/>
              </p:ext>
            </p:extLst>
          </p:nvPr>
        </p:nvGraphicFramePr>
        <p:xfrm>
          <a:off x="2143125" y="1747838"/>
          <a:ext cx="1716088" cy="1646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2" name="Prism 6" r:id="rId4" imgW="1851480" imgH="1775160" progId="Prism6.Document">
                  <p:embed/>
                </p:oleObj>
              </mc:Choice>
              <mc:Fallback>
                <p:oleObj name="Prism 6" r:id="rId4" imgW="1851480" imgH="17751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43125" y="1747838"/>
                        <a:ext cx="1716088" cy="1646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5987911"/>
              </p:ext>
            </p:extLst>
          </p:nvPr>
        </p:nvGraphicFramePr>
        <p:xfrm>
          <a:off x="3556000" y="1760538"/>
          <a:ext cx="1716088" cy="1639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3" name="Prism 6" r:id="rId6" imgW="1851480" imgH="1766160" progId="Prism6.Document">
                  <p:embed/>
                </p:oleObj>
              </mc:Choice>
              <mc:Fallback>
                <p:oleObj name="Prism 6" r:id="rId6" imgW="1851480" imgH="17661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56000" y="1760538"/>
                        <a:ext cx="1716088" cy="1639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9463835"/>
              </p:ext>
            </p:extLst>
          </p:nvPr>
        </p:nvGraphicFramePr>
        <p:xfrm>
          <a:off x="2160588" y="3646488"/>
          <a:ext cx="1695450" cy="1627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4" name="Prism 6" r:id="rId8" imgW="1825560" imgH="1753920" progId="Prism6.Document">
                  <p:embed/>
                </p:oleObj>
              </mc:Choice>
              <mc:Fallback>
                <p:oleObj name="Prism 6" r:id="rId8" imgW="1825560" imgH="17539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160588" y="3646488"/>
                        <a:ext cx="1695450" cy="1627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6930024"/>
              </p:ext>
            </p:extLst>
          </p:nvPr>
        </p:nvGraphicFramePr>
        <p:xfrm>
          <a:off x="3635375" y="3646488"/>
          <a:ext cx="1695450" cy="1627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5" name="Prism 6" r:id="rId10" imgW="1825560" imgH="1753920" progId="Prism6.Document">
                  <p:embed/>
                </p:oleObj>
              </mc:Choice>
              <mc:Fallback>
                <p:oleObj name="Prism 6" r:id="rId10" imgW="1825560" imgH="17539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35375" y="3646488"/>
                        <a:ext cx="1695450" cy="1627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08" name="Group 107"/>
          <p:cNvGrpSpPr/>
          <p:nvPr/>
        </p:nvGrpSpPr>
        <p:grpSpPr>
          <a:xfrm>
            <a:off x="509028" y="3433594"/>
            <a:ext cx="1693077" cy="1958949"/>
            <a:chOff x="568561" y="2775158"/>
            <a:chExt cx="1693077" cy="1958949"/>
          </a:xfrm>
        </p:grpSpPr>
        <p:grpSp>
          <p:nvGrpSpPr>
            <p:cNvPr id="72" name="Group 71"/>
            <p:cNvGrpSpPr/>
            <p:nvPr/>
          </p:nvGrpSpPr>
          <p:grpSpPr>
            <a:xfrm>
              <a:off x="568561" y="2775158"/>
              <a:ext cx="1693077" cy="1958949"/>
              <a:chOff x="3219569" y="2167891"/>
              <a:chExt cx="1693077" cy="1958949"/>
            </a:xfrm>
          </p:grpSpPr>
          <p:grpSp>
            <p:nvGrpSpPr>
              <p:cNvPr id="77" name="Group 6"/>
              <p:cNvGrpSpPr>
                <a:grpSpLocks/>
              </p:cNvGrpSpPr>
              <p:nvPr/>
            </p:nvGrpSpPr>
            <p:grpSpPr bwMode="auto">
              <a:xfrm>
                <a:off x="3527858" y="2438196"/>
                <a:ext cx="1384788" cy="261572"/>
                <a:chOff x="203500" y="566109"/>
                <a:chExt cx="1811337" cy="432138"/>
              </a:xfrm>
            </p:grpSpPr>
            <p:sp>
              <p:nvSpPr>
                <p:cNvPr id="86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203500" y="566109"/>
                  <a:ext cx="900565" cy="4194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algn="ctr"/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gG</a:t>
                  </a:r>
                  <a:endParaRPr lang="en-GB" altLang="en-US" sz="1050" i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958553" y="578757"/>
                  <a:ext cx="1056284" cy="4194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algn="r"/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a</a:t>
                  </a:r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ICOS-L</a:t>
                  </a:r>
                  <a:endParaRPr lang="en-GB" altLang="en-US" sz="1050" i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8" name="TextBox 1"/>
              <p:cNvSpPr txBox="1">
                <a:spLocks noChangeArrowheads="1"/>
              </p:cNvSpPr>
              <p:nvPr/>
            </p:nvSpPr>
            <p:spPr bwMode="auto">
              <a:xfrm>
                <a:off x="3232577" y="2558509"/>
                <a:ext cx="644515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9pPr>
              </a:lstStyle>
              <a:p>
                <a:r>
                  <a:rPr lang="en-GB" altLang="en-US" sz="1100" i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LN</a:t>
                </a:r>
                <a:endParaRPr lang="en-GB" altLang="en-US" sz="1100" i="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TextBox 1"/>
              <p:cNvSpPr txBox="1">
                <a:spLocks noChangeArrowheads="1"/>
              </p:cNvSpPr>
              <p:nvPr/>
            </p:nvSpPr>
            <p:spPr bwMode="auto">
              <a:xfrm>
                <a:off x="3219569" y="3159412"/>
                <a:ext cx="538402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600" i="1">
                    <a:solidFill>
                      <a:srgbClr val="6E6E6F"/>
                    </a:solidFill>
                    <a:latin typeface="Verdana" panose="020B0604030504040204" pitchFamily="34" charset="0"/>
                    <a:ea typeface="MS PGothic" panose="020B0600070205080204" pitchFamily="34" charset="-128"/>
                  </a:defRPr>
                </a:lvl9pPr>
              </a:lstStyle>
              <a:p>
                <a:r>
                  <a:rPr lang="en-GB" altLang="en-US" sz="1050" i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ung</a:t>
                </a:r>
                <a:endParaRPr lang="en-GB" altLang="en-US" sz="1000" i="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 rot="5400000">
                <a:off x="4154762" y="2072182"/>
                <a:ext cx="346249" cy="53766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3827978" y="2434471"/>
                <a:ext cx="900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Arrow Connector 81"/>
              <p:cNvCxnSpPr/>
              <p:nvPr/>
            </p:nvCxnSpPr>
            <p:spPr>
              <a:xfrm>
                <a:off x="3590014" y="3878749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Arrow Connector 82"/>
              <p:cNvCxnSpPr/>
              <p:nvPr/>
            </p:nvCxnSpPr>
            <p:spPr>
              <a:xfrm flipV="1">
                <a:off x="3599537" y="3420097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/>
              <p:cNvSpPr txBox="1"/>
              <p:nvPr/>
            </p:nvSpPr>
            <p:spPr>
              <a:xfrm rot="16200000">
                <a:off x="2819183" y="3199038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8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3684935" y="3865230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7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950988" y="3225511"/>
              <a:ext cx="1224000" cy="1220644"/>
              <a:chOff x="-2542040" y="6093771"/>
              <a:chExt cx="1224000" cy="1220644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-1930040" y="6108193"/>
                <a:ext cx="612000" cy="61200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-2542040" y="6696864"/>
                <a:ext cx="612000" cy="612000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-1930040" y="6702415"/>
                <a:ext cx="612000" cy="612000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-2533496" y="6093771"/>
                <a:ext cx="612000" cy="612000"/>
              </a:xfrm>
              <a:prstGeom prst="rect">
                <a:avLst/>
              </a:prstGeom>
            </p:spPr>
          </p:pic>
        </p:grpSp>
      </p:grpSp>
      <p:grpSp>
        <p:nvGrpSpPr>
          <p:cNvPr id="136" name="Group 135"/>
          <p:cNvGrpSpPr/>
          <p:nvPr/>
        </p:nvGrpSpPr>
        <p:grpSpPr>
          <a:xfrm>
            <a:off x="511149" y="1509848"/>
            <a:ext cx="1748169" cy="1962408"/>
            <a:chOff x="512804" y="560376"/>
            <a:chExt cx="1748169" cy="1962408"/>
          </a:xfrm>
        </p:grpSpPr>
        <p:grpSp>
          <p:nvGrpSpPr>
            <p:cNvPr id="89" name="Group 88"/>
            <p:cNvGrpSpPr/>
            <p:nvPr/>
          </p:nvGrpSpPr>
          <p:grpSpPr>
            <a:xfrm>
              <a:off x="512804" y="560376"/>
              <a:ext cx="1748169" cy="1247524"/>
              <a:chOff x="557641" y="450597"/>
              <a:chExt cx="1748169" cy="1247524"/>
            </a:xfrm>
          </p:grpSpPr>
          <p:grpSp>
            <p:nvGrpSpPr>
              <p:cNvPr id="96" name="Group 95"/>
              <p:cNvGrpSpPr/>
              <p:nvPr/>
            </p:nvGrpSpPr>
            <p:grpSpPr>
              <a:xfrm>
                <a:off x="557641" y="710958"/>
                <a:ext cx="1748169" cy="987163"/>
                <a:chOff x="653231" y="161842"/>
                <a:chExt cx="1748169" cy="987163"/>
              </a:xfrm>
            </p:grpSpPr>
            <p:grpSp>
              <p:nvGrpSpPr>
                <p:cNvPr id="102" name="Group 2"/>
                <p:cNvGrpSpPr>
                  <a:grpSpLocks/>
                </p:cNvGrpSpPr>
                <p:nvPr/>
              </p:nvGrpSpPr>
              <p:grpSpPr bwMode="auto">
                <a:xfrm>
                  <a:off x="653231" y="161842"/>
                  <a:ext cx="1748169" cy="419554"/>
                  <a:chOff x="470973" y="1100172"/>
                  <a:chExt cx="2286649" cy="693136"/>
                </a:xfrm>
              </p:grpSpPr>
              <p:grpSp>
                <p:nvGrpSpPr>
                  <p:cNvPr id="104" name="Group 6"/>
                  <p:cNvGrpSpPr>
                    <a:grpSpLocks/>
                  </p:cNvGrpSpPr>
                  <p:nvPr/>
                </p:nvGrpSpPr>
                <p:grpSpPr bwMode="auto">
                  <a:xfrm>
                    <a:off x="910942" y="1100172"/>
                    <a:ext cx="1846680" cy="427529"/>
                    <a:chOff x="172884" y="429628"/>
                    <a:chExt cx="1846680" cy="427529"/>
                  </a:xfrm>
                </p:grpSpPr>
                <p:sp>
                  <p:nvSpPr>
                    <p:cNvPr id="106" name="TextBox 1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72884" y="429628"/>
                      <a:ext cx="900565" cy="4194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algn="ctr"/>
                      <a:r>
                        <a:rPr lang="en-GB" altLang="en-US" sz="1050" i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G</a:t>
                      </a:r>
                      <a:endParaRPr lang="en-GB" altLang="en-US" sz="1050" i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07" name="TextBox 1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63282" y="437668"/>
                      <a:ext cx="1056282" cy="4194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algn="r"/>
                      <a:r>
                        <a:rPr lang="en-GB" altLang="en-US" sz="1050" i="0" dirty="0" smtClean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GB" altLang="en-US" sz="1050" i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ICOS-L</a:t>
                      </a:r>
                      <a:endParaRPr lang="en-GB" altLang="en-US" sz="1050" i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05" name="TextBox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70973" y="1361108"/>
                    <a:ext cx="843042" cy="4322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1pPr>
                    <a:lvl2pPr marL="742950" indent="-28575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2pPr>
                    <a:lvl3pPr marL="11430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r>
                      <a:rPr lang="en-GB" altLang="en-US" sz="1100" i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LN</a:t>
                    </a:r>
                    <a:endParaRPr lang="en-GB" altLang="en-US" sz="1100" i="0" baseline="-25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3" name="TextBox 1"/>
                <p:cNvSpPr txBox="1">
                  <a:spLocks noChangeArrowheads="1"/>
                </p:cNvSpPr>
                <p:nvPr/>
              </p:nvSpPr>
              <p:spPr bwMode="auto">
                <a:xfrm>
                  <a:off x="672340" y="895089"/>
                  <a:ext cx="538402" cy="2539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600" i="1">
                      <a:solidFill>
                        <a:srgbClr val="6E6E6F"/>
                      </a:solidFill>
                      <a:latin typeface="Verdana" panose="020B060403050404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r>
                    <a:rPr lang="en-GB" altLang="en-US" sz="1050" i="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ung</a:t>
                  </a:r>
                  <a:endParaRPr lang="en-GB" altLang="en-US" sz="1050" i="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0" name="TextBox 99"/>
              <p:cNvSpPr txBox="1"/>
              <p:nvPr/>
            </p:nvSpPr>
            <p:spPr>
              <a:xfrm rot="5400000">
                <a:off x="1543647" y="354888"/>
                <a:ext cx="346249" cy="53766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  <a:scene3d>
                  <a:camera prst="orthographicFront">
                    <a:rot lat="0" lon="0" rev="0"/>
                  </a:camera>
                  <a:lightRig rig="threePt" dir="t"/>
                </a:scene3d>
              </a:bodyPr>
              <a:lstStyle/>
              <a:p>
                <a:r>
                  <a:rPr lang="en-GB" sz="10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1" name="Straight Connector 100"/>
              <p:cNvCxnSpPr/>
              <p:nvPr/>
            </p:nvCxnSpPr>
            <p:spPr>
              <a:xfrm>
                <a:off x="1171598" y="717177"/>
                <a:ext cx="900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 89"/>
            <p:cNvGrpSpPr/>
            <p:nvPr/>
          </p:nvGrpSpPr>
          <p:grpSpPr>
            <a:xfrm>
              <a:off x="686069" y="1102535"/>
              <a:ext cx="1241140" cy="1420249"/>
              <a:chOff x="1037865" y="3936208"/>
              <a:chExt cx="1241140" cy="1420249"/>
            </a:xfrm>
          </p:grpSpPr>
          <p:cxnSp>
            <p:nvCxnSpPr>
              <p:cNvPr id="91" name="Straight Arrow Connector 90"/>
              <p:cNvCxnSpPr/>
              <p:nvPr/>
            </p:nvCxnSpPr>
            <p:spPr>
              <a:xfrm>
                <a:off x="1268286" y="5108366"/>
                <a:ext cx="468001" cy="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Arrow Connector 91"/>
              <p:cNvCxnSpPr/>
              <p:nvPr/>
            </p:nvCxnSpPr>
            <p:spPr>
              <a:xfrm flipV="1">
                <a:off x="1277809" y="4653996"/>
                <a:ext cx="767" cy="46800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92"/>
              <p:cNvSpPr txBox="1"/>
              <p:nvPr/>
            </p:nvSpPr>
            <p:spPr>
              <a:xfrm rot="16200000">
                <a:off x="531577" y="4442496"/>
                <a:ext cx="12741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CR5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1363207" y="5094847"/>
                <a:ext cx="91579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D1</a:t>
                </a:r>
                <a:endPara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5" name="Group 114"/>
            <p:cNvGrpSpPr/>
            <p:nvPr/>
          </p:nvGrpSpPr>
          <p:grpSpPr>
            <a:xfrm>
              <a:off x="880076" y="965820"/>
              <a:ext cx="1274654" cy="1271694"/>
              <a:chOff x="-2759165" y="2250803"/>
              <a:chExt cx="1274654" cy="1271694"/>
            </a:xfrm>
          </p:grpSpPr>
          <p:pic>
            <p:nvPicPr>
              <p:cNvPr id="120" name="Picture 119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-2751892" y="2250803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121" name="Picture 120"/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-2150511" y="2258865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122" name="Picture 121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-2759165" y="2854466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123" name="Picture 122"/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-2160829" y="2856497"/>
                <a:ext cx="666000" cy="666000"/>
              </a:xfrm>
              <a:prstGeom prst="rect">
                <a:avLst/>
              </a:prstGeom>
            </p:spPr>
          </p:pic>
        </p:grpSp>
      </p:grpSp>
      <p:sp>
        <p:nvSpPr>
          <p:cNvPr id="137" name="TextBox 136"/>
          <p:cNvSpPr txBox="1"/>
          <p:nvPr/>
        </p:nvSpPr>
        <p:spPr>
          <a:xfrm>
            <a:off x="509028" y="1540700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09028" y="3401965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02458" y="531685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522036" y="7341745"/>
            <a:ext cx="577369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6: ICOS signalling is required to sustain T</a:t>
            </a:r>
            <a:r>
              <a:rPr lang="en-GB" sz="1000" b="1" baseline="-25000" dirty="0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during ALT driven chronic AAD.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female BALB/c mice were exposed 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.n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to 10 µg alternaria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alternata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(ALT) or 25 µl phosphate buffered saline (PBS), 3 times a week for 5 weeks. From the start of week 4 mice were also administered 150 µg anti-ICOS-L (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) or isotype control (IgG) antibody 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3 times a week. Mice were culled at the end of week 5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chematic of experimental design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flow plots of mLN and lung T</a:t>
            </a:r>
            <a:r>
              <a:rPr lang="en-GB" sz="1000" baseline="-25000" dirty="0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following ALT and IgG or 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 treatment. The data is quantified for all group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presentative flow plots of mLN and lung germinal centre (GC) B cells following ALT and IgG or </a:t>
            </a:r>
            <a:r>
              <a:rPr lang="el-GR" sz="1000" dirty="0" smtClean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-ICOS-L treatment. Pre-gated on CD19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B220</a:t>
            </a:r>
            <a:r>
              <a:rPr lang="en-GB" sz="10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B cells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Representative flow plots of mLN and lung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plasmablasts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ollowing ALT and IgG or 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 treatment. Pre-gated on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lymphocytes. 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Plasmablast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s are quantified for all groups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tatistica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ignificance was determined using a Mann Whitney U test. 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p&lt;0.001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Experiment was performed once. n=4 for PBS treated groups, n=6 for ALT treated groups.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09028" y="563156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35061" y="591627"/>
            <a:ext cx="2379582" cy="1049685"/>
          </a:xfrm>
          <a:prstGeom prst="rect">
            <a:avLst/>
          </a:prstGeom>
        </p:spPr>
      </p:pic>
      <p:grpSp>
        <p:nvGrpSpPr>
          <p:cNvPr id="57" name="Group 56"/>
          <p:cNvGrpSpPr/>
          <p:nvPr/>
        </p:nvGrpSpPr>
        <p:grpSpPr>
          <a:xfrm>
            <a:off x="491763" y="5325356"/>
            <a:ext cx="1831670" cy="2037689"/>
            <a:chOff x="564082" y="575210"/>
            <a:chExt cx="1831670" cy="2037689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660284" y="1013156"/>
              <a:ext cx="666000" cy="666000"/>
            </a:xfrm>
            <a:prstGeom prst="rect">
              <a:avLst/>
            </a:prstGeom>
          </p:spPr>
        </p:pic>
        <p:grpSp>
          <p:nvGrpSpPr>
            <p:cNvPr id="59" name="Group 58"/>
            <p:cNvGrpSpPr/>
            <p:nvPr/>
          </p:nvGrpSpPr>
          <p:grpSpPr>
            <a:xfrm>
              <a:off x="564082" y="575210"/>
              <a:ext cx="1831670" cy="2037689"/>
              <a:chOff x="564082" y="575210"/>
              <a:chExt cx="1831670" cy="2037689"/>
            </a:xfrm>
          </p:grpSpPr>
          <p:grpSp>
            <p:nvGrpSpPr>
              <p:cNvPr id="61" name="Group 60"/>
              <p:cNvGrpSpPr/>
              <p:nvPr/>
            </p:nvGrpSpPr>
            <p:grpSpPr>
              <a:xfrm>
                <a:off x="564082" y="575210"/>
                <a:ext cx="1831670" cy="1267229"/>
                <a:chOff x="557641" y="499041"/>
                <a:chExt cx="1831670" cy="1267229"/>
              </a:xfrm>
            </p:grpSpPr>
            <p:grpSp>
              <p:nvGrpSpPr>
                <p:cNvPr id="69" name="Group 68"/>
                <p:cNvGrpSpPr/>
                <p:nvPr/>
              </p:nvGrpSpPr>
              <p:grpSpPr>
                <a:xfrm>
                  <a:off x="557641" y="759402"/>
                  <a:ext cx="1831670" cy="1006868"/>
                  <a:chOff x="653231" y="210286"/>
                  <a:chExt cx="1831670" cy="1006868"/>
                </a:xfrm>
              </p:grpSpPr>
              <p:grpSp>
                <p:nvGrpSpPr>
                  <p:cNvPr id="73" name="Group 2"/>
                  <p:cNvGrpSpPr>
                    <a:grpSpLocks/>
                  </p:cNvGrpSpPr>
                  <p:nvPr/>
                </p:nvGrpSpPr>
                <p:grpSpPr bwMode="auto">
                  <a:xfrm>
                    <a:off x="653231" y="210286"/>
                    <a:ext cx="1831670" cy="401679"/>
                    <a:chOff x="470973" y="1180205"/>
                    <a:chExt cx="2395871" cy="663605"/>
                  </a:xfrm>
                </p:grpSpPr>
                <p:grpSp>
                  <p:nvGrpSpPr>
                    <p:cNvPr id="75" name="Group 6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020165" y="1180205"/>
                      <a:ext cx="1846679" cy="427530"/>
                      <a:chOff x="282107" y="509661"/>
                      <a:chExt cx="1846679" cy="427530"/>
                    </a:xfrm>
                  </p:grpSpPr>
                  <p:sp>
                    <p:nvSpPr>
                      <p:cNvPr id="88" name="TextBox 1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82107" y="509661"/>
                        <a:ext cx="900565" cy="41948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1pPr>
                        <a:lvl2pPr marL="742950" indent="-28575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2pPr>
                        <a:lvl3pPr marL="11430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3pPr>
                        <a:lvl4pPr marL="16002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4pPr>
                        <a:lvl5pPr marL="20574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9pPr>
                      </a:lstStyle>
                      <a:p>
                        <a:pPr algn="ctr"/>
                        <a:r>
                          <a:rPr lang="en-GB" altLang="en-US" sz="1050" i="0" dirty="0" smtClean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gG</a:t>
                        </a:r>
                        <a:endParaRPr lang="en-GB" altLang="en-US" sz="105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95" name="TextBox 16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072504" y="517702"/>
                        <a:ext cx="1056282" cy="41948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square">
                        <a:spAutoFit/>
                      </a:bodyPr>
                      <a:lstStyle>
                        <a:lvl1pPr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1pPr>
                        <a:lvl2pPr marL="742950" indent="-28575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2pPr>
                        <a:lvl3pPr marL="11430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3pPr>
                        <a:lvl4pPr marL="16002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4pPr>
                        <a:lvl5pPr marL="2057400" indent="-228600"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5pPr>
                        <a:lvl6pPr marL="25146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6pPr>
                        <a:lvl7pPr marL="29718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7pPr>
                        <a:lvl8pPr marL="34290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8pPr>
                        <a:lvl9pPr marL="3886200" indent="-2286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sz="1600" i="1">
                            <a:solidFill>
                              <a:srgbClr val="6E6E6F"/>
                            </a:solidFill>
                            <a:latin typeface="Verdana" panose="020B0604030504040204" pitchFamily="34" charset="0"/>
                            <a:ea typeface="MS PGothic" panose="020B0600070205080204" pitchFamily="34" charset="-128"/>
                          </a:defRPr>
                        </a:lvl9pPr>
                      </a:lstStyle>
                      <a:p>
                        <a:pPr algn="r"/>
                        <a:r>
                          <a:rPr lang="en-GB" altLang="en-US" sz="1050" i="0" dirty="0" smtClean="0">
                            <a:solidFill>
                              <a:schemeClr val="tx1"/>
                            </a:solidFill>
                            <a:latin typeface="Symbol" panose="05050102010706020507" pitchFamily="18" charset="2"/>
                            <a:cs typeface="Times New Roman" panose="02020603050405020304" pitchFamily="18" charset="0"/>
                          </a:rPr>
                          <a:t>a</a:t>
                        </a:r>
                        <a:r>
                          <a:rPr lang="en-GB" altLang="en-US" sz="1050" i="0" dirty="0" smtClean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-ICOS-L</a:t>
                        </a:r>
                        <a:endParaRPr lang="en-GB" altLang="en-US" sz="1050" i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76" name="TextBox 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70973" y="1411610"/>
                      <a:ext cx="843042" cy="4322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sz="1600" i="1">
                          <a:solidFill>
                            <a:srgbClr val="6E6E6F"/>
                          </a:solidFill>
                          <a:latin typeface="Verdana" panose="020B060403050404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r>
                        <a:rPr lang="en-GB" altLang="en-US" sz="1100" i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N</a:t>
                      </a:r>
                      <a:endParaRPr lang="en-GB" altLang="en-US" sz="1100" i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74" name="TextBox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6148" y="963238"/>
                    <a:ext cx="538402" cy="2539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1pPr>
                    <a:lvl2pPr marL="742950" indent="-28575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2pPr>
                    <a:lvl3pPr marL="11430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3pPr>
                    <a:lvl4pPr marL="16002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4pPr>
                    <a:lvl5pPr marL="2057400" indent="-228600"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600" i="1">
                        <a:solidFill>
                          <a:srgbClr val="6E6E6F"/>
                        </a:solidFill>
                        <a:latin typeface="Verdana" panose="020B0604030504040204" pitchFamily="34" charset="0"/>
                        <a:ea typeface="MS PGothic" panose="020B0600070205080204" pitchFamily="34" charset="-128"/>
                      </a:defRPr>
                    </a:lvl9pPr>
                  </a:lstStyle>
                  <a:p>
                    <a:r>
                      <a:rPr lang="en-GB" altLang="en-US" sz="1050" i="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Lung</a:t>
                    </a:r>
                    <a:endParaRPr lang="en-GB" altLang="en-US" sz="1050" i="0" baseline="-250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70" name="TextBox 69"/>
                <p:cNvSpPr txBox="1"/>
                <p:nvPr/>
              </p:nvSpPr>
              <p:spPr>
                <a:xfrm rot="5400000">
                  <a:off x="1627149" y="403332"/>
                  <a:ext cx="346249" cy="537668"/>
                </a:xfrm>
                <a:prstGeom prst="rect">
                  <a:avLst/>
                </a:prstGeom>
                <a:noFill/>
              </p:spPr>
              <p:txBody>
                <a:bodyPr vert="vert270" wrap="square" rtlCol="0">
                  <a:spAutoFit/>
                  <a:scene3d>
                    <a:camera prst="orthographicFront">
                      <a:rot lat="0" lon="0" rev="0"/>
                    </a:camera>
                    <a:lightRig rig="threePt" dir="t"/>
                  </a:scene3d>
                </a:bodyPr>
                <a:lstStyle/>
                <a:p>
                  <a:r>
                    <a:rPr lang="en-GB" sz="105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LT</a:t>
                  </a:r>
                  <a:endPara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1" name="Straight Connector 70"/>
                <p:cNvCxnSpPr/>
                <p:nvPr/>
              </p:nvCxnSpPr>
              <p:spPr>
                <a:xfrm>
                  <a:off x="1255100" y="765621"/>
                  <a:ext cx="900000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Group 61"/>
              <p:cNvGrpSpPr/>
              <p:nvPr/>
            </p:nvGrpSpPr>
            <p:grpSpPr>
              <a:xfrm>
                <a:off x="765923" y="1192650"/>
                <a:ext cx="1241140" cy="1420249"/>
                <a:chOff x="1037865" y="4017069"/>
                <a:chExt cx="1241140" cy="1420249"/>
              </a:xfrm>
            </p:grpSpPr>
            <p:cxnSp>
              <p:nvCxnSpPr>
                <p:cNvPr id="65" name="Straight Arrow Connector 64"/>
                <p:cNvCxnSpPr/>
                <p:nvPr/>
              </p:nvCxnSpPr>
              <p:spPr>
                <a:xfrm>
                  <a:off x="1268286" y="5189227"/>
                  <a:ext cx="468001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Arrow Connector 65"/>
                <p:cNvCxnSpPr/>
                <p:nvPr/>
              </p:nvCxnSpPr>
              <p:spPr>
                <a:xfrm flipV="1">
                  <a:off x="1277809" y="4734857"/>
                  <a:ext cx="767" cy="46800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TextBox 66"/>
                <p:cNvSpPr txBox="1"/>
                <p:nvPr/>
              </p:nvSpPr>
              <p:spPr>
                <a:xfrm rot="16200000">
                  <a:off x="531577" y="4523357"/>
                  <a:ext cx="1274185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220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1363207" y="5175708"/>
                  <a:ext cx="91579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38</a:t>
                  </a:r>
                  <a:endPara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1014754" y="1014638"/>
                <a:ext cx="666000" cy="666000"/>
              </a:xfrm>
              <a:prstGeom prst="rect">
                <a:avLst/>
              </a:prstGeom>
            </p:spPr>
          </p:pic>
          <p:pic>
            <p:nvPicPr>
              <p:cNvPr id="64" name="Picture 63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1008385" y="1671660"/>
                <a:ext cx="666000" cy="666000"/>
              </a:xfrm>
              <a:prstGeom prst="rect">
                <a:avLst/>
              </a:prstGeom>
            </p:spPr>
          </p:pic>
        </p:grpSp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654915" y="1670178"/>
              <a:ext cx="666000" cy="666000"/>
            </a:xfrm>
            <a:prstGeom prst="rect">
              <a:avLst/>
            </a:prstGeom>
          </p:spPr>
        </p:pic>
      </p:grpSp>
      <p:graphicFrame>
        <p:nvGraphicFramePr>
          <p:cNvPr id="97" name="Object 9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8902958"/>
              </p:ext>
            </p:extLst>
          </p:nvPr>
        </p:nvGraphicFramePr>
        <p:xfrm>
          <a:off x="3573769" y="5542678"/>
          <a:ext cx="175817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6" name="Prism 6" r:id="rId25" imgW="2343600" imgH="2159280" progId="Prism6.Document">
                  <p:embed/>
                </p:oleObj>
              </mc:Choice>
              <mc:Fallback>
                <p:oleObj name="Prism 6" r:id="rId25" imgW="2343600" imgH="21592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3573769" y="5542678"/>
                        <a:ext cx="175817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8" name="Object 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3691917"/>
              </p:ext>
            </p:extLst>
          </p:nvPr>
        </p:nvGraphicFramePr>
        <p:xfrm>
          <a:off x="2115455" y="5564281"/>
          <a:ext cx="174219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9587" name="Prism 6" r:id="rId27" imgW="2286000" imgH="2125800" progId="Prism6.Document">
                  <p:embed/>
                </p:oleObj>
              </mc:Choice>
              <mc:Fallback>
                <p:oleObj name="Prism 6" r:id="rId27" imgW="2286000" imgH="212580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115455" y="5564281"/>
                        <a:ext cx="174219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36573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7"/>
          <p:cNvSpPr txBox="1"/>
          <p:nvPr/>
        </p:nvSpPr>
        <p:spPr>
          <a:xfrm>
            <a:off x="618790" y="608975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2466828"/>
              </p:ext>
            </p:extLst>
          </p:nvPr>
        </p:nvGraphicFramePr>
        <p:xfrm>
          <a:off x="3942432" y="774701"/>
          <a:ext cx="1847850" cy="174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0385" name="Prism 6" r:id="rId3" imgW="2302560" imgH="2172960" progId="Prism6.Document">
                  <p:embed/>
                </p:oleObj>
              </mc:Choice>
              <mc:Fallback>
                <p:oleObj name="Prism 6" r:id="rId3" imgW="2302560" imgH="217296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42432" y="774701"/>
                        <a:ext cx="1847850" cy="174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9809409"/>
              </p:ext>
            </p:extLst>
          </p:nvPr>
        </p:nvGraphicFramePr>
        <p:xfrm>
          <a:off x="622300" y="828675"/>
          <a:ext cx="1954213" cy="1754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0386" name="Prism 6" r:id="rId5" imgW="1953720" imgH="1753920" progId="Prism6.Document">
                  <p:embed/>
                </p:oleObj>
              </mc:Choice>
              <mc:Fallback>
                <p:oleObj name="Prism 6" r:id="rId5" imgW="1953720" imgH="17539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2300" y="828675"/>
                        <a:ext cx="1954213" cy="1754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4" name="Object 7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049201"/>
              </p:ext>
            </p:extLst>
          </p:nvPr>
        </p:nvGraphicFramePr>
        <p:xfrm>
          <a:off x="2170113" y="828675"/>
          <a:ext cx="1917700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0387" name="Prism 6" r:id="rId7" imgW="1917000" imgH="1752480" progId="Prism6.Document">
                  <p:embed/>
                </p:oleObj>
              </mc:Choice>
              <mc:Fallback>
                <p:oleObj name="Prism 6" r:id="rId7" imgW="1917000" imgH="17524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70113" y="828675"/>
                        <a:ext cx="1917700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Box 74"/>
          <p:cNvSpPr txBox="1"/>
          <p:nvPr/>
        </p:nvSpPr>
        <p:spPr>
          <a:xfrm>
            <a:off x="3942432" y="62081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618790" y="2673252"/>
            <a:ext cx="577369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7: ICOS-L blockade reduces allergen specific IgE.</a:t>
            </a: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were expose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(i.n) to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10 µg alternaria alternata (ALT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or 25 µl phosphate buffered saline (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BS), 3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times a week for 5 weeks. From the start of week 4 mice were also administered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150 µg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body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. Mice were culled at the end of week 5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erum was titrated and allergen specific antibody was measured by ELISA. Endpoint titres are displayed for IgE and IgG1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erum MCPT1 was determined by ELISA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Statistical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ignificance was determined using a Mann Whitney U test. 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 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p&lt;0.001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Experimen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was performed once. n=4 for PBS treated groups, n=6 for ALT treated groups.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4297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87530" y="4675188"/>
            <a:ext cx="5594195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S8: 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Therapeutic ICOS-L blockade improves chronic allergic airway disease. </a:t>
            </a:r>
            <a:endParaRPr lang="en-GB" sz="1000" b="1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defRPr/>
            </a:pP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female BALB/c mice were exposed (i.n) to 10 µg alternaria alternata (ALT) or 25 µl phosphate buffered saline (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BS),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3 times a week for 5 weeks. From the start of week 4 mice were also administered 150 µg anti-ICOS-L (</a:t>
            </a:r>
            <a:r>
              <a:rPr lang="el-GR" sz="1000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ICOS-L) or isotype control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tibody (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i.p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) 3 times a week. Mice were culled at the end of week 5.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Number of lung cells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Lung eosinophil numbers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Proportions of lung eosinophils, 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irway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hyperresponsiveness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was measured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by exposing mice to 0-100mg/ml methacholine (</a:t>
            </a:r>
            <a:r>
              <a:rPr lang="en-GB" sz="1000" dirty="0" err="1">
                <a:latin typeface="Arial" charset="0"/>
                <a:ea typeface="Arial" charset="0"/>
                <a:cs typeface="Arial" charset="0"/>
              </a:rPr>
              <a:t>MCh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using the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flexiVent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system during ALT induced allergic airway disease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irway</a:t>
            </a:r>
            <a:r>
              <a:rPr lang="en-GB" sz="10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resistance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elastance and compliance were measured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Curves display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mean±SEM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Statistical significance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between ALT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 IgG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and 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ALT+</a:t>
            </a:r>
            <a:r>
              <a:rPr lang="en-GB" sz="1000" dirty="0" err="1" smtClean="0">
                <a:latin typeface="Symbol" charset="2"/>
                <a:ea typeface="Symbol" charset="2"/>
                <a:cs typeface="Symbol" charset="2"/>
              </a:rPr>
              <a:t>a</a:t>
            </a:r>
            <a:r>
              <a:rPr lang="en-GB" sz="1000" dirty="0" err="1" smtClean="0">
                <a:latin typeface="Arial" charset="0"/>
                <a:ea typeface="Arial" charset="0"/>
                <a:cs typeface="Arial" charset="0"/>
              </a:rPr>
              <a:t>-ICOS-L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 groups was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determined using a Mann Whitney U test.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5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p&lt;0.01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, ***</a:t>
            </a:r>
            <a:r>
              <a:rPr lang="en-GB" sz="1000" i="1" dirty="0" smtClean="0">
                <a:latin typeface="Arial" charset="0"/>
                <a:ea typeface="Arial" charset="0"/>
                <a:cs typeface="Arial" charset="0"/>
              </a:rPr>
              <a:t>p&lt;0.001. </a:t>
            </a:r>
            <a:r>
              <a:rPr lang="en-GB" sz="1000" i="1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Experiment was performed once. n=4 for PBS treated groups, n=6 for </a:t>
            </a:r>
            <a:r>
              <a:rPr lang="en-GB" sz="1000" dirty="0" smtClean="0">
                <a:latin typeface="Arial" charset="0"/>
                <a:ea typeface="Arial" charset="0"/>
                <a:cs typeface="Arial" charset="0"/>
              </a:rPr>
              <a:t>ALT 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treated groups. </a:t>
            </a:r>
            <a:endParaRPr lang="en-GB" sz="10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87530" y="665181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357877" y="655656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0045" y="2543413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0907088"/>
              </p:ext>
            </p:extLst>
          </p:nvPr>
        </p:nvGraphicFramePr>
        <p:xfrm>
          <a:off x="549275" y="754063"/>
          <a:ext cx="2020888" cy="193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1" name="Prism 6" r:id="rId4" imgW="2020680" imgH="1933920" progId="Prism6.Document">
                  <p:embed/>
                </p:oleObj>
              </mc:Choice>
              <mc:Fallback>
                <p:oleObj name="Prism 6" r:id="rId4" imgW="2020680" imgH="19339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9275" y="754063"/>
                        <a:ext cx="2020888" cy="193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0995112"/>
              </p:ext>
            </p:extLst>
          </p:nvPr>
        </p:nvGraphicFramePr>
        <p:xfrm>
          <a:off x="2347913" y="765176"/>
          <a:ext cx="2019300" cy="19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2" name="Prism 6" r:id="rId6" imgW="2019240" imgH="1923120" progId="Prism6.Document">
                  <p:embed/>
                </p:oleObj>
              </mc:Choice>
              <mc:Fallback>
                <p:oleObj name="Prism 6" r:id="rId6" imgW="2019240" imgH="19231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47913" y="765176"/>
                        <a:ext cx="2019300" cy="1922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8115996"/>
              </p:ext>
            </p:extLst>
          </p:nvPr>
        </p:nvGraphicFramePr>
        <p:xfrm>
          <a:off x="582613" y="2603500"/>
          <a:ext cx="1973262" cy="190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3" name="Prism 6" r:id="rId8" imgW="1973520" imgH="1903320" progId="Prism6.Document">
                  <p:embed/>
                </p:oleObj>
              </mc:Choice>
              <mc:Fallback>
                <p:oleObj name="Prism 6" r:id="rId8" imgW="1973520" imgH="190332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82613" y="2603500"/>
                        <a:ext cx="1973262" cy="1903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4623984"/>
              </p:ext>
            </p:extLst>
          </p:nvPr>
        </p:nvGraphicFramePr>
        <p:xfrm>
          <a:off x="2280990" y="2603737"/>
          <a:ext cx="2036763" cy="189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4" name="Prism 6" r:id="rId10" imgW="2037240" imgH="1898640" progId="Prism6.Document">
                  <p:embed/>
                </p:oleObj>
              </mc:Choice>
              <mc:Fallback>
                <p:oleObj name="Prism 6" r:id="rId10" imgW="2037240" imgH="18986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80990" y="2603737"/>
                        <a:ext cx="2036763" cy="189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3816886"/>
              </p:ext>
            </p:extLst>
          </p:nvPr>
        </p:nvGraphicFramePr>
        <p:xfrm>
          <a:off x="3929383" y="2603737"/>
          <a:ext cx="2051050" cy="2000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5" name="Prism 6" r:id="rId12" imgW="2051280" imgH="2000880" progId="Prism6.Document">
                  <p:embed/>
                </p:oleObj>
              </mc:Choice>
              <mc:Fallback>
                <p:oleObj name="Prism 6" r:id="rId12" imgW="2051280" imgH="200088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929383" y="2603737"/>
                        <a:ext cx="2051050" cy="2000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0018302"/>
              </p:ext>
            </p:extLst>
          </p:nvPr>
        </p:nvGraphicFramePr>
        <p:xfrm>
          <a:off x="3946525" y="711200"/>
          <a:ext cx="2068513" cy="1976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546" name="Prism 6" r:id="rId14" imgW="2069280" imgH="1976400" progId="Prism6.Document">
                  <p:embed/>
                </p:oleObj>
              </mc:Choice>
              <mc:Fallback>
                <p:oleObj name="Prism 6" r:id="rId14" imgW="2069280" imgH="197640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946525" y="711200"/>
                        <a:ext cx="2068513" cy="1976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3931303" y="655656"/>
            <a:ext cx="374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5002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764</TotalTime>
  <Words>2409</Words>
  <Application>Microsoft Office PowerPoint</Application>
  <PresentationFormat>A4 Paper (210x297 mm)</PresentationFormat>
  <Paragraphs>357</Paragraphs>
  <Slides>13</Slides>
  <Notes>8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MS PGothic</vt:lpstr>
      <vt:lpstr>Arial</vt:lpstr>
      <vt:lpstr>Calibri</vt:lpstr>
      <vt:lpstr>Calibri Light</vt:lpstr>
      <vt:lpstr>Symbol</vt:lpstr>
      <vt:lpstr>Times New Roman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SR Figures</dc:title>
  <dc:creator>Uwadiae, Faith</dc:creator>
  <cp:lastModifiedBy>Uwadiae, Faith</cp:lastModifiedBy>
  <cp:revision>1242</cp:revision>
  <cp:lastPrinted>2018-02-27T18:36:17Z</cp:lastPrinted>
  <dcterms:created xsi:type="dcterms:W3CDTF">2016-06-08T14:58:03Z</dcterms:created>
  <dcterms:modified xsi:type="dcterms:W3CDTF">2018-06-26T15:02:29Z</dcterms:modified>
</cp:coreProperties>
</file>